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3" r:id="rId2"/>
    <p:sldId id="282" r:id="rId3"/>
    <p:sldId id="275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58"/>
  </p:normalViewPr>
  <p:slideViewPr>
    <p:cSldViewPr snapToGrid="0">
      <p:cViewPr varScale="1">
        <p:scale>
          <a:sx n="120" d="100"/>
          <a:sy n="120" d="100"/>
        </p:scale>
        <p:origin x="80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84286A-C04C-1A88-2FBB-36029A08E29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96D980F-B42C-A033-E15C-6B9D6A60BE7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5485DB-74C7-CD6D-0419-3700C743C3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660266-23EB-314D-9FD5-D269BA816DB9}" type="datetimeFigureOut">
              <a:rPr lang="en-US" smtClean="0"/>
              <a:t>2/3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E89F88-8EF9-E8E1-945C-F16112F9FF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55444A-FF39-C6C4-DCBC-7088193140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635A4-574B-0841-8CE0-0B4DEF26B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5336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C8A354-6797-4300-955F-FB4CDD414E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34C92D5-3D4D-B56A-C03A-37BA21800E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66E36E-4634-7FCB-3227-DE3D3EB004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660266-23EB-314D-9FD5-D269BA816DB9}" type="datetimeFigureOut">
              <a:rPr lang="en-US" smtClean="0"/>
              <a:t>2/3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C12BE0-F59E-CFC2-CF3C-7192535719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E510C5-721B-D15A-168A-35214F89FE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635A4-574B-0841-8CE0-0B4DEF26B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10747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42766D7-C6BA-1D28-7FB0-4DE64A9937A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F3FFA06-2294-F02F-7595-F8B550B16B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93C822-9010-F785-FF5A-73A8FBBB52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660266-23EB-314D-9FD5-D269BA816DB9}" type="datetimeFigureOut">
              <a:rPr lang="en-US" smtClean="0"/>
              <a:t>2/3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48E095-A3BF-5928-6072-747A34D83C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B39B33-F8AA-7ACB-5945-31298D3127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635A4-574B-0841-8CE0-0B4DEF26B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25809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F1F83A-2CA7-FD54-4FAB-255F600102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8FCAC3F-AAF2-D41C-037B-41335E14F24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3DA74B-3911-8769-034E-1BBBBDBAC8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660266-23EB-314D-9FD5-D269BA816DB9}" type="datetimeFigureOut">
              <a:rPr lang="en-US" smtClean="0"/>
              <a:t>2/3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095A31-EDAC-8FB8-27FC-2E899397D6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DE3FFD-AFE2-B143-F646-5635AB00CF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635A4-574B-0841-8CE0-0B4DEF26B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88665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BECFE6-2711-D779-6FA3-D685B3D723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710EDD4-2C52-AA3F-F0EB-D19163D6C8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62FC86-92A8-941F-4E94-999A25FA8D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660266-23EB-314D-9FD5-D269BA816DB9}" type="datetimeFigureOut">
              <a:rPr lang="en-US" smtClean="0"/>
              <a:t>2/3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C94644-1A4D-C05F-81CD-676854D9B4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F2B798-90C4-DCFF-394E-681D594328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635A4-574B-0841-8CE0-0B4DEF26B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74785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B10127-FA15-7D96-BACA-0E7DBB67A3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8D844D-999B-F7B2-CBC1-2F37CEB22BD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E11F4A2-B90B-55D9-81EC-DA15450623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1C6809-8D3A-D170-D61C-A24B52BE6B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660266-23EB-314D-9FD5-D269BA816DB9}" type="datetimeFigureOut">
              <a:rPr lang="en-US" smtClean="0"/>
              <a:t>2/3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838F6FE-1602-AEFC-46CE-31F5BF4575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264F142-B509-FA33-9D71-87089568BD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635A4-574B-0841-8CE0-0B4DEF26B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40952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EA81CD-CCA6-0280-0F8E-BF373827BA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D275413-C72C-EC31-1CC4-ED930A1BE8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E0D000C-E35C-0E12-2ACE-A9EC224FCFB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612B318-DB14-D947-1961-7F5FE2D25DD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B030E4A-A8DB-77F0-2EB7-9B15D971419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10AF18C-62F6-4916-5F7D-F4B9D4993A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660266-23EB-314D-9FD5-D269BA816DB9}" type="datetimeFigureOut">
              <a:rPr lang="en-US" smtClean="0"/>
              <a:t>2/3/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44F1D0A-47C3-5EF8-2EA1-6B3A0D72B9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892ACAD-F6CF-DFCF-168C-6AA60F1EE2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635A4-574B-0841-8CE0-0B4DEF26B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57026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BFB84D-43AA-CC12-1F7D-050E4E809E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B236F37-A4AB-E7B7-903D-30B7A86CF2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660266-23EB-314D-9FD5-D269BA816DB9}" type="datetimeFigureOut">
              <a:rPr lang="en-US" smtClean="0"/>
              <a:t>2/3/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78BFB5E-B2F5-A55D-1F05-396BCAAA81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A34143B-70CA-FBED-A029-B069F5A89F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635A4-574B-0841-8CE0-0B4DEF26B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1317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A3BDB53-0D94-8C95-888B-F76C751AFD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660266-23EB-314D-9FD5-D269BA816DB9}" type="datetimeFigureOut">
              <a:rPr lang="en-US" smtClean="0"/>
              <a:t>2/3/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5C9F33B-4FC9-E2AD-4823-8DE377A8B6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DA0CE7F-F8E2-239A-6904-0640378593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635A4-574B-0841-8CE0-0B4DEF26B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2774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4D4D46-A9FC-7405-BE21-3FD8F8E5B9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0889B99-380C-108F-618D-19ED1B8DC5D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9F92771-407E-9319-7A3C-73780C896B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1503EA9-B27A-7751-A7CF-5054A08073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660266-23EB-314D-9FD5-D269BA816DB9}" type="datetimeFigureOut">
              <a:rPr lang="en-US" smtClean="0"/>
              <a:t>2/3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3DF7BF-DFDF-3240-3984-B13AD7BACD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91DFC7E-6F7F-8F47-47C3-F6E41BEEE5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635A4-574B-0841-8CE0-0B4DEF26B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46226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63D964-B0DB-F5A4-7200-9206CFEE58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9235EB4-C4B1-0DEB-060A-7D1838E358E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9759757-3636-1BA1-7F87-AAFF96E4E7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7F326D2-04BA-23C5-10EF-C30DF7F58C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660266-23EB-314D-9FD5-D269BA816DB9}" type="datetimeFigureOut">
              <a:rPr lang="en-US" smtClean="0"/>
              <a:t>2/3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EC8DA48-F6C4-3B83-D403-BB6E442940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D99D854-F3FA-F73C-10D3-952C4FE363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635A4-574B-0841-8CE0-0B4DEF26B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24210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9A19EFA-DA47-63C9-99EF-FA4B1A217D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449CED1-647C-0744-397F-9DBB577B0C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38BC31-B578-EE4A-E385-792FB288350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5660266-23EB-314D-9FD5-D269BA816DB9}" type="datetimeFigureOut">
              <a:rPr lang="en-US" smtClean="0"/>
              <a:t>2/3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0DB35F-58F2-5E98-707F-EA426606B84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F62516-C4AA-9592-0AFD-A63603E84CF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E4635A4-574B-0841-8CE0-0B4DEF26B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57548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>
        <mc:Choice xmlns:a14="http://schemas.microsoft.com/office/drawing/2010/main" Requires="a14">
          <p:graphicFrame>
            <p:nvGraphicFramePr>
              <p:cNvPr id="2" name="Table 1">
                <a:extLst>
                  <a:ext uri="{FF2B5EF4-FFF2-40B4-BE49-F238E27FC236}">
                    <a16:creationId xmlns:a16="http://schemas.microsoft.com/office/drawing/2014/main" id="{9C18051A-6653-19C1-6852-1AAC7C137134}"/>
                  </a:ext>
                </a:extLst>
              </p:cNvPr>
              <p:cNvGraphicFramePr>
                <a:graphicFrameLocks noGrp="1"/>
              </p:cNvGraphicFramePr>
              <p:nvPr/>
            </p:nvGraphicFramePr>
            <p:xfrm>
              <a:off x="632464" y="172453"/>
              <a:ext cx="11127144" cy="6091826"/>
            </p:xfrm>
            <a:graphic>
              <a:graphicData uri="http://schemas.openxmlformats.org/drawingml/2006/table">
                <a:tbl>
                  <a:tblPr firstRow="1" firstCol="1" bandRow="1">
                    <a:tableStyleId>{5940675A-B579-460E-94D1-54222C63F5DA}</a:tableStyleId>
                  </a:tblPr>
                  <a:tblGrid>
                    <a:gridCol w="1133164">
                      <a:extLst>
                        <a:ext uri="{9D8B030D-6E8A-4147-A177-3AD203B41FA5}">
                          <a16:colId xmlns:a16="http://schemas.microsoft.com/office/drawing/2014/main" val="1949119216"/>
                        </a:ext>
                      </a:extLst>
                    </a:gridCol>
                    <a:gridCol w="999398">
                      <a:extLst>
                        <a:ext uri="{9D8B030D-6E8A-4147-A177-3AD203B41FA5}">
                          <a16:colId xmlns:a16="http://schemas.microsoft.com/office/drawing/2014/main" val="834352100"/>
                        </a:ext>
                      </a:extLst>
                    </a:gridCol>
                    <a:gridCol w="999398">
                      <a:extLst>
                        <a:ext uri="{9D8B030D-6E8A-4147-A177-3AD203B41FA5}">
                          <a16:colId xmlns:a16="http://schemas.microsoft.com/office/drawing/2014/main" val="2740627536"/>
                        </a:ext>
                      </a:extLst>
                    </a:gridCol>
                    <a:gridCol w="999398">
                      <a:extLst>
                        <a:ext uri="{9D8B030D-6E8A-4147-A177-3AD203B41FA5}">
                          <a16:colId xmlns:a16="http://schemas.microsoft.com/office/drawing/2014/main" val="392156696"/>
                        </a:ext>
                      </a:extLst>
                    </a:gridCol>
                    <a:gridCol w="999398">
                      <a:extLst>
                        <a:ext uri="{9D8B030D-6E8A-4147-A177-3AD203B41FA5}">
                          <a16:colId xmlns:a16="http://schemas.microsoft.com/office/drawing/2014/main" val="1899616324"/>
                        </a:ext>
                      </a:extLst>
                    </a:gridCol>
                    <a:gridCol w="999398">
                      <a:extLst>
                        <a:ext uri="{9D8B030D-6E8A-4147-A177-3AD203B41FA5}">
                          <a16:colId xmlns:a16="http://schemas.microsoft.com/office/drawing/2014/main" val="4077769823"/>
                        </a:ext>
                      </a:extLst>
                    </a:gridCol>
                    <a:gridCol w="999398">
                      <a:extLst>
                        <a:ext uri="{9D8B030D-6E8A-4147-A177-3AD203B41FA5}">
                          <a16:colId xmlns:a16="http://schemas.microsoft.com/office/drawing/2014/main" val="3058248615"/>
                        </a:ext>
                      </a:extLst>
                    </a:gridCol>
                    <a:gridCol w="999398">
                      <a:extLst>
                        <a:ext uri="{9D8B030D-6E8A-4147-A177-3AD203B41FA5}">
                          <a16:colId xmlns:a16="http://schemas.microsoft.com/office/drawing/2014/main" val="771218125"/>
                        </a:ext>
                      </a:extLst>
                    </a:gridCol>
                    <a:gridCol w="999398">
                      <a:extLst>
                        <a:ext uri="{9D8B030D-6E8A-4147-A177-3AD203B41FA5}">
                          <a16:colId xmlns:a16="http://schemas.microsoft.com/office/drawing/2014/main" val="137810377"/>
                        </a:ext>
                      </a:extLst>
                    </a:gridCol>
                    <a:gridCol w="999398">
                      <a:extLst>
                        <a:ext uri="{9D8B030D-6E8A-4147-A177-3AD203B41FA5}">
                          <a16:colId xmlns:a16="http://schemas.microsoft.com/office/drawing/2014/main" val="274157669"/>
                        </a:ext>
                      </a:extLst>
                    </a:gridCol>
                    <a:gridCol w="999398">
                      <a:extLst>
                        <a:ext uri="{9D8B030D-6E8A-4147-A177-3AD203B41FA5}">
                          <a16:colId xmlns:a16="http://schemas.microsoft.com/office/drawing/2014/main" val="274360666"/>
                        </a:ext>
                      </a:extLst>
                    </a:gridCol>
                  </a:tblGrid>
                  <a:tr h="176440">
                    <a:tc rowSpan="2">
                      <a:txBody>
                        <a:bodyPr/>
                        <a:lstStyle/>
                        <a:p>
                          <a:pPr marL="0" marR="0" algn="l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 </a:t>
                          </a:r>
                        </a:p>
                        <a:p>
                          <a:pPr marL="0" marR="0" algn="l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 </a:t>
                          </a:r>
                        </a:p>
                      </a:txBody>
                      <a:tcPr marL="68580" marR="68580" marT="0" marB="0">
                        <a:solidFill>
                          <a:schemeClr val="bg2"/>
                        </a:solidFill>
                      </a:tcPr>
                    </a:tc>
                    <a:tc gridSpan="7">
                      <a:txBody>
                        <a:bodyPr/>
                        <a:lstStyle/>
                        <a:p>
                          <a:pPr algn="ctr"/>
                          <a:r>
                            <a:rPr lang="en-US" sz="1200" b="1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Mixed-Curation</a:t>
                          </a:r>
                          <a:r>
                            <a:rPr lang="en-US" sz="120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 </a:t>
                          </a: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models</a:t>
                          </a:r>
                          <a:endParaRPr lang="en-US" sz="120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gridSpan="3"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Highly curated models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extLst>
                      <a:ext uri="{0D108BD9-81ED-4DB2-BD59-A6C34878D82A}">
                        <a16:rowId xmlns:a16="http://schemas.microsoft.com/office/drawing/2014/main" val="192860897"/>
                      </a:ext>
                    </a:extLst>
                  </a:tr>
                  <a:tr h="352067">
                    <a:tc vMerge="1">
                      <a:txBody>
                        <a:bodyPr/>
                        <a:lstStyle/>
                        <a:p>
                          <a:pPr marL="0" marR="0" algn="l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+mn-lt"/>
                              <a:ea typeface="+mn-ea"/>
                              <a:cs typeface="+mn-cs"/>
                            </a:rPr>
                            <a:t> </a:t>
                          </a: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56-scan 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142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284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710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1420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2130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2840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56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142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244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3026451276"/>
                      </a:ext>
                    </a:extLst>
                  </a:tr>
                  <a:tr h="177219">
                    <a:tc gridSpan="11">
                      <a:txBody>
                        <a:bodyPr/>
                        <a:lstStyle/>
                        <a:p>
                          <a:pPr marL="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DSC</a:t>
                          </a:r>
                        </a:p>
                      </a:txBody>
                      <a:tcPr marL="68580" marR="68580" marT="0" marB="0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3137752485"/>
                      </a:ext>
                    </a:extLst>
                  </a:tr>
                  <a:tr h="825046">
                    <a:tc>
                      <a:txBody>
                        <a:bodyPr/>
                        <a:lstStyle/>
                        <a:p>
                          <a:pPr marL="11430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Versus minimally curated 56-scan model</a:t>
                          </a: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sz="1200" b="1" kern="100" dirty="0">
                              <a:effectLst/>
                              <a:latin typeface="Arial" panose="020B0604020202020204" pitchFamily="34" charset="0"/>
                              <a:ea typeface="Cambria Math" panose="02040503050406030204" pitchFamily="18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4129130750"/>
                      </a:ext>
                    </a:extLst>
                  </a:tr>
                  <a:tr h="852794">
                    <a:tc>
                      <a:txBody>
                        <a:bodyPr/>
                        <a:lstStyle/>
                        <a:p>
                          <a:pPr marL="11430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Versus highly curated 244-scan model</a:t>
                          </a: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𝟏𝟗𝟕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g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g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g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g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sz="1200" b="1" kern="100">
                              <a:effectLst/>
                              <a:latin typeface="Arial" panose="020B0604020202020204" pitchFamily="34" charset="0"/>
                              <a:ea typeface="Cambria Math" panose="02040503050406030204" pitchFamily="18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3615192787"/>
                      </a:ext>
                    </a:extLst>
                  </a:tr>
                  <a:tr h="173070">
                    <a:tc gridSpan="11">
                      <a:txBody>
                        <a:bodyPr/>
                        <a:lstStyle/>
                        <a:p>
                          <a:pPr marL="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Hausdorff distance, 95th percentile</a:t>
                          </a:r>
                        </a:p>
                      </a:txBody>
                      <a:tcPr marL="68580" marR="68580" marT="0" marB="0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1293607918"/>
                      </a:ext>
                    </a:extLst>
                  </a:tr>
                  <a:tr h="825046">
                    <a:tc>
                      <a:txBody>
                        <a:bodyPr/>
                        <a:lstStyle/>
                        <a:p>
                          <a:pPr marL="11430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Versus minimally curated 56-scan model</a:t>
                          </a: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ctr" rtl="0" fontAlgn="b"/>
                          <a:r>
                            <a:rPr lang="en-US" sz="1200" b="1" i="0" u="none" strike="noStrike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Cambria Math" panose="02040503050406030204" pitchFamily="18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1678689836"/>
                      </a:ext>
                    </a:extLst>
                  </a:tr>
                  <a:tr h="852794">
                    <a:tc>
                      <a:txBody>
                        <a:bodyPr/>
                        <a:lstStyle/>
                        <a:p>
                          <a:pPr marL="11430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Versus highly curated 244-scan model</a:t>
                          </a: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𝟐𝟓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b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u="none" strike="noStrike" dirty="0" smtClean="0">
                                    <a:solidFill>
                                      <a:srgbClr val="000000"/>
                                    </a:solidFill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</m:t>
                                </m:r>
                                <m:r>
                                  <a:rPr lang="en-US" sz="1200" b="1" i="1" u="none" strike="noStrike" dirty="0" smtClean="0">
                                    <a:solidFill>
                                      <a:srgbClr val="000000"/>
                                    </a:solidFill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.</m:t>
                                </m:r>
                                <m:r>
                                  <a:rPr lang="en-US" sz="1200" b="1" i="1" u="none" strike="noStrike" dirty="0" smtClean="0">
                                    <a:solidFill>
                                      <a:srgbClr val="000000"/>
                                    </a:solidFill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𝟐𝟑𝟖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g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g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g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𝟗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g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b"/>
                          <a:r>
                            <a:rPr lang="en-US" sz="1200" b="1" i="0" u="none" strike="noStrike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Cambria Math" panose="02040503050406030204" pitchFamily="18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3958423156"/>
                      </a:ext>
                    </a:extLst>
                  </a:tr>
                  <a:tr h="173070">
                    <a:tc gridSpan="11">
                      <a:txBody>
                        <a:bodyPr/>
                        <a:lstStyle/>
                        <a:p>
                          <a:pPr marL="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Surface DSC with 2-mm margins</a:t>
                          </a:r>
                        </a:p>
                      </a:txBody>
                      <a:tcPr marL="68580" marR="68580" marT="0" marB="0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1786108808"/>
                      </a:ext>
                    </a:extLst>
                  </a:tr>
                  <a:tr h="825046">
                    <a:tc>
                      <a:txBody>
                        <a:bodyPr/>
                        <a:lstStyle/>
                        <a:p>
                          <a:pPr marL="11430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Versus minimally curated 56-scan model</a:t>
                          </a: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:r>
                            <a:rPr lang="en-US" sz="1200" b="1" i="0" u="none" strike="noStrike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Cambria Math" panose="02040503050406030204" pitchFamily="18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2757718277"/>
                      </a:ext>
                    </a:extLst>
                  </a:tr>
                  <a:tr h="852794">
                    <a:tc>
                      <a:txBody>
                        <a:bodyPr/>
                        <a:lstStyle/>
                        <a:p>
                          <a:pPr marL="11430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Versus highly curated 244-scan model</a:t>
                          </a: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𝟏𝟎𝟐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g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g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g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g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sz="1200" b="1" i="0" u="none" strike="noStrike" dirty="0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Cambria Math" panose="02040503050406030204" pitchFamily="18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897063501"/>
                      </a:ext>
                    </a:extLst>
                  </a:tr>
                </a:tbl>
              </a:graphicData>
            </a:graphic>
          </p:graphicFrame>
        </mc:Choice>
        <mc:Fallback>
          <p:graphicFrame>
            <p:nvGraphicFramePr>
              <p:cNvPr id="2" name="Table 1">
                <a:extLst>
                  <a:ext uri="{FF2B5EF4-FFF2-40B4-BE49-F238E27FC236}">
                    <a16:creationId xmlns:a16="http://schemas.microsoft.com/office/drawing/2014/main" id="{9C18051A-6653-19C1-6852-1AAC7C137134}"/>
                  </a:ext>
                </a:extLst>
              </p:cNvPr>
              <p:cNvGraphicFramePr>
                <a:graphicFrameLocks noGrp="1"/>
              </p:cNvGraphicFramePr>
              <p:nvPr/>
            </p:nvGraphicFramePr>
            <p:xfrm>
              <a:off x="632464" y="172453"/>
              <a:ext cx="11127144" cy="6091826"/>
            </p:xfrm>
            <a:graphic>
              <a:graphicData uri="http://schemas.openxmlformats.org/drawingml/2006/table">
                <a:tbl>
                  <a:tblPr firstRow="1" firstCol="1" bandRow="1">
                    <a:tableStyleId>{5940675A-B579-460E-94D1-54222C63F5DA}</a:tableStyleId>
                  </a:tblPr>
                  <a:tblGrid>
                    <a:gridCol w="1133164">
                      <a:extLst>
                        <a:ext uri="{9D8B030D-6E8A-4147-A177-3AD203B41FA5}">
                          <a16:colId xmlns:a16="http://schemas.microsoft.com/office/drawing/2014/main" val="1949119216"/>
                        </a:ext>
                      </a:extLst>
                    </a:gridCol>
                    <a:gridCol w="999398">
                      <a:extLst>
                        <a:ext uri="{9D8B030D-6E8A-4147-A177-3AD203B41FA5}">
                          <a16:colId xmlns:a16="http://schemas.microsoft.com/office/drawing/2014/main" val="834352100"/>
                        </a:ext>
                      </a:extLst>
                    </a:gridCol>
                    <a:gridCol w="999398">
                      <a:extLst>
                        <a:ext uri="{9D8B030D-6E8A-4147-A177-3AD203B41FA5}">
                          <a16:colId xmlns:a16="http://schemas.microsoft.com/office/drawing/2014/main" val="2740627536"/>
                        </a:ext>
                      </a:extLst>
                    </a:gridCol>
                    <a:gridCol w="999398">
                      <a:extLst>
                        <a:ext uri="{9D8B030D-6E8A-4147-A177-3AD203B41FA5}">
                          <a16:colId xmlns:a16="http://schemas.microsoft.com/office/drawing/2014/main" val="392156696"/>
                        </a:ext>
                      </a:extLst>
                    </a:gridCol>
                    <a:gridCol w="999398">
                      <a:extLst>
                        <a:ext uri="{9D8B030D-6E8A-4147-A177-3AD203B41FA5}">
                          <a16:colId xmlns:a16="http://schemas.microsoft.com/office/drawing/2014/main" val="1899616324"/>
                        </a:ext>
                      </a:extLst>
                    </a:gridCol>
                    <a:gridCol w="999398">
                      <a:extLst>
                        <a:ext uri="{9D8B030D-6E8A-4147-A177-3AD203B41FA5}">
                          <a16:colId xmlns:a16="http://schemas.microsoft.com/office/drawing/2014/main" val="4077769823"/>
                        </a:ext>
                      </a:extLst>
                    </a:gridCol>
                    <a:gridCol w="999398">
                      <a:extLst>
                        <a:ext uri="{9D8B030D-6E8A-4147-A177-3AD203B41FA5}">
                          <a16:colId xmlns:a16="http://schemas.microsoft.com/office/drawing/2014/main" val="3058248615"/>
                        </a:ext>
                      </a:extLst>
                    </a:gridCol>
                    <a:gridCol w="999398">
                      <a:extLst>
                        <a:ext uri="{9D8B030D-6E8A-4147-A177-3AD203B41FA5}">
                          <a16:colId xmlns:a16="http://schemas.microsoft.com/office/drawing/2014/main" val="771218125"/>
                        </a:ext>
                      </a:extLst>
                    </a:gridCol>
                    <a:gridCol w="999398">
                      <a:extLst>
                        <a:ext uri="{9D8B030D-6E8A-4147-A177-3AD203B41FA5}">
                          <a16:colId xmlns:a16="http://schemas.microsoft.com/office/drawing/2014/main" val="137810377"/>
                        </a:ext>
                      </a:extLst>
                    </a:gridCol>
                    <a:gridCol w="999398">
                      <a:extLst>
                        <a:ext uri="{9D8B030D-6E8A-4147-A177-3AD203B41FA5}">
                          <a16:colId xmlns:a16="http://schemas.microsoft.com/office/drawing/2014/main" val="274157669"/>
                        </a:ext>
                      </a:extLst>
                    </a:gridCol>
                    <a:gridCol w="999398">
                      <a:extLst>
                        <a:ext uri="{9D8B030D-6E8A-4147-A177-3AD203B41FA5}">
                          <a16:colId xmlns:a16="http://schemas.microsoft.com/office/drawing/2014/main" val="274360666"/>
                        </a:ext>
                      </a:extLst>
                    </a:gridCol>
                  </a:tblGrid>
                  <a:tr h="182880">
                    <a:tc rowSpan="2">
                      <a:txBody>
                        <a:bodyPr/>
                        <a:lstStyle/>
                        <a:p>
                          <a:pPr marL="0" marR="0" algn="l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 </a:t>
                          </a:r>
                        </a:p>
                        <a:p>
                          <a:pPr marL="0" marR="0" algn="l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 </a:t>
                          </a:r>
                        </a:p>
                      </a:txBody>
                      <a:tcPr marL="68580" marR="68580" marT="0" marB="0">
                        <a:solidFill>
                          <a:schemeClr val="bg2"/>
                        </a:solidFill>
                      </a:tcPr>
                    </a:tc>
                    <a:tc gridSpan="7">
                      <a:txBody>
                        <a:bodyPr/>
                        <a:lstStyle/>
                        <a:p>
                          <a:pPr algn="ctr"/>
                          <a:r>
                            <a:rPr lang="en-US" sz="1200" b="1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Mixed-Curation</a:t>
                          </a:r>
                          <a:r>
                            <a:rPr lang="en-US" sz="120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 </a:t>
                          </a: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models</a:t>
                          </a:r>
                          <a:endParaRPr lang="en-US" sz="120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gridSpan="3"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Highly curated models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extLst>
                      <a:ext uri="{0D108BD9-81ED-4DB2-BD59-A6C34878D82A}">
                        <a16:rowId xmlns:a16="http://schemas.microsoft.com/office/drawing/2014/main" val="192860897"/>
                      </a:ext>
                    </a:extLst>
                  </a:tr>
                  <a:tr h="352067">
                    <a:tc vMerge="1">
                      <a:txBody>
                        <a:bodyPr/>
                        <a:lstStyle/>
                        <a:p>
                          <a:pPr marL="0" marR="0" algn="l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+mn-lt"/>
                              <a:ea typeface="+mn-ea"/>
                              <a:cs typeface="+mn-cs"/>
                            </a:rPr>
                            <a:t> </a:t>
                          </a: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56-scan 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142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284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710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1420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2130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2840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56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142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244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3026451276"/>
                      </a:ext>
                    </a:extLst>
                  </a:tr>
                  <a:tr h="177219">
                    <a:tc gridSpan="11">
                      <a:txBody>
                        <a:bodyPr/>
                        <a:lstStyle/>
                        <a:p>
                          <a:pPr marL="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DSC</a:t>
                          </a:r>
                        </a:p>
                      </a:txBody>
                      <a:tcPr marL="68580" marR="68580" marT="0" marB="0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3137752485"/>
                      </a:ext>
                    </a:extLst>
                  </a:tr>
                  <a:tr h="825046">
                    <a:tc>
                      <a:txBody>
                        <a:bodyPr/>
                        <a:lstStyle/>
                        <a:p>
                          <a:pPr marL="11430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Versus minimally curated 56-scan model</a:t>
                          </a: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sz="1200" b="1" kern="100" dirty="0">
                              <a:effectLst/>
                              <a:latin typeface="Arial" panose="020B0604020202020204" pitchFamily="34" charset="0"/>
                              <a:ea typeface="Cambria Math" panose="02040503050406030204" pitchFamily="18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213924" t="-92308" r="-800000" b="-555385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313924" t="-92308" r="-700000" b="-555385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419231" t="-92308" r="-608974" b="-555385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512658" t="-92308" r="-501266" b="-555385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612658" t="-92308" r="-401266" b="-555385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712658" t="-92308" r="-301266" b="-555385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823077" t="-92308" r="-205128" b="-555385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911392" t="-92308" r="-102532" b="-555385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1011392" t="-92308" r="-2532" b="-555385"/>
                          </a:stretch>
                        </a:blipFill>
                      </a:tcPr>
                    </a:tc>
                    <a:extLst>
                      <a:ext uri="{0D108BD9-81ED-4DB2-BD59-A6C34878D82A}">
                        <a16:rowId xmlns:a16="http://schemas.microsoft.com/office/drawing/2014/main" val="4129130750"/>
                      </a:ext>
                    </a:extLst>
                  </a:tr>
                  <a:tr h="852794">
                    <a:tc>
                      <a:txBody>
                        <a:bodyPr/>
                        <a:lstStyle/>
                        <a:p>
                          <a:pPr marL="11430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Versus highly curated 244-scan model</a:t>
                          </a: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113924" t="-183824" r="-900000" b="-430882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213924" t="-183824" r="-800000" b="-430882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313924" t="-183824" r="-700000" b="-430882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419231" t="-183824" r="-608974" b="-430882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512658" t="-183824" r="-501266" b="-430882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612658" t="-183824" r="-401266" b="-430882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712658" t="-183824" r="-301266" b="-430882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823077" t="-183824" r="-205128" b="-430882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911392" t="-183824" r="-102532" b="-430882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sz="1200" b="1" kern="100">
                              <a:effectLst/>
                              <a:latin typeface="Arial" panose="020B0604020202020204" pitchFamily="34" charset="0"/>
                              <a:ea typeface="Cambria Math" panose="02040503050406030204" pitchFamily="18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3615192787"/>
                      </a:ext>
                    </a:extLst>
                  </a:tr>
                  <a:tr h="173070">
                    <a:tc gridSpan="11">
                      <a:txBody>
                        <a:bodyPr/>
                        <a:lstStyle/>
                        <a:p>
                          <a:pPr marL="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Hausdorff distance, 95th percentile</a:t>
                          </a:r>
                        </a:p>
                      </a:txBody>
                      <a:tcPr marL="68580" marR="68580" marT="0" marB="0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1293607918"/>
                      </a:ext>
                    </a:extLst>
                  </a:tr>
                  <a:tr h="825046">
                    <a:tc>
                      <a:txBody>
                        <a:bodyPr/>
                        <a:lstStyle/>
                        <a:p>
                          <a:pPr marL="11430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Versus minimally curated 56-scan model</a:t>
                          </a: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ctr" rtl="0" fontAlgn="b"/>
                          <a:r>
                            <a:rPr lang="en-US" sz="1200" b="1" i="0" u="none" strike="noStrike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Cambria Math" panose="02040503050406030204" pitchFamily="18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213924" t="-312121" r="-800000" b="-324242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313924" t="-312121" r="-700000" b="-324242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419231" t="-312121" r="-608974" b="-324242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512658" t="-312121" r="-501266" b="-324242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612658" t="-312121" r="-401266" b="-324242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712658" t="-312121" r="-301266" b="-324242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823077" t="-312121" r="-205128" b="-324242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911392" t="-312121" r="-102532" b="-324242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1011392" t="-312121" r="-2532" b="-324242"/>
                          </a:stretch>
                        </a:blipFill>
                      </a:tcPr>
                    </a:tc>
                    <a:extLst>
                      <a:ext uri="{0D108BD9-81ED-4DB2-BD59-A6C34878D82A}">
                        <a16:rowId xmlns:a16="http://schemas.microsoft.com/office/drawing/2014/main" val="1678689836"/>
                      </a:ext>
                    </a:extLst>
                  </a:tr>
                  <a:tr h="852794">
                    <a:tc>
                      <a:txBody>
                        <a:bodyPr/>
                        <a:lstStyle/>
                        <a:p>
                          <a:pPr marL="11430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Versus highly curated 244-scan model</a:t>
                          </a: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113924" t="-405970" r="-900000" b="-219403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213924" t="-405970" r="-800000" b="-219403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313924" t="-405970" r="-700000" b="-219403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419231" t="-405970" r="-608974" b="-219403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512658" t="-405970" r="-501266" b="-219403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612658" t="-405970" r="-401266" b="-219403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712658" t="-405970" r="-301266" b="-219403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823077" t="-405970" r="-205128" b="-219403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911392" t="-405970" r="-102532" b="-219403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pPr algn="ctr" rtl="0" fontAlgn="b"/>
                          <a:r>
                            <a:rPr lang="en-US" sz="1200" b="1" i="0" u="none" strike="noStrike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Cambria Math" panose="02040503050406030204" pitchFamily="18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3958423156"/>
                      </a:ext>
                    </a:extLst>
                  </a:tr>
                  <a:tr h="173070">
                    <a:tc gridSpan="11">
                      <a:txBody>
                        <a:bodyPr/>
                        <a:lstStyle/>
                        <a:p>
                          <a:pPr marL="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Surface DSC with 2-mm margins</a:t>
                          </a:r>
                        </a:p>
                      </a:txBody>
                      <a:tcPr marL="68580" marR="68580" marT="0" marB="0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1786108808"/>
                      </a:ext>
                    </a:extLst>
                  </a:tr>
                  <a:tr h="825046">
                    <a:tc>
                      <a:txBody>
                        <a:bodyPr/>
                        <a:lstStyle/>
                        <a:p>
                          <a:pPr marL="11430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Versus minimally curated 56-scan model</a:t>
                          </a: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:r>
                            <a:rPr lang="en-US" sz="1200" b="1" i="0" u="none" strike="noStrike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Cambria Math" panose="02040503050406030204" pitchFamily="18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213924" t="-543077" r="-800000" b="-104615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313924" t="-543077" r="-700000" b="-104615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419231" t="-543077" r="-608974" b="-104615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512658" t="-543077" r="-501266" b="-104615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612658" t="-543077" r="-401266" b="-104615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712658" t="-543077" r="-301266" b="-104615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823077" t="-543077" r="-205128" b="-104615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911392" t="-543077" r="-102532" b="-104615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1011392" t="-543077" r="-2532" b="-104615"/>
                          </a:stretch>
                        </a:blipFill>
                      </a:tcPr>
                    </a:tc>
                    <a:extLst>
                      <a:ext uri="{0D108BD9-81ED-4DB2-BD59-A6C34878D82A}">
                        <a16:rowId xmlns:a16="http://schemas.microsoft.com/office/drawing/2014/main" val="2757718277"/>
                      </a:ext>
                    </a:extLst>
                  </a:tr>
                  <a:tr h="852794">
                    <a:tc>
                      <a:txBody>
                        <a:bodyPr/>
                        <a:lstStyle/>
                        <a:p>
                          <a:pPr marL="11430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Versus highly curated 244-scan model</a:t>
                          </a: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113924" t="-623881" r="-900000" b="-1493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213924" t="-623881" r="-800000" b="-1493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313924" t="-623881" r="-700000" b="-1493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419231" t="-623881" r="-608974" b="-1493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512658" t="-623881" r="-501266" b="-1493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612658" t="-623881" r="-401266" b="-1493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712658" t="-623881" r="-301266" b="-1493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823077" t="-623881" r="-205128" b="-1493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911392" t="-623881" r="-102532" b="-1493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sz="1200" b="1" i="0" u="none" strike="noStrike" dirty="0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Cambria Math" panose="02040503050406030204" pitchFamily="18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897063501"/>
                      </a:ext>
                    </a:extLst>
                  </a:tr>
                </a:tbl>
              </a:graphicData>
            </a:graphic>
          </p:graphicFrame>
        </mc:Fallback>
      </mc:AlternateContent>
      <p:sp>
        <p:nvSpPr>
          <p:cNvPr id="5" name="TextBox 4">
            <a:extLst>
              <a:ext uri="{FF2B5EF4-FFF2-40B4-BE49-F238E27FC236}">
                <a16:creationId xmlns:a16="http://schemas.microsoft.com/office/drawing/2014/main" id="{2CF8F054-F76B-8623-1C1E-D2DC27F22BCF}"/>
              </a:ext>
            </a:extLst>
          </p:cNvPr>
          <p:cNvSpPr txBox="1"/>
          <p:nvPr/>
        </p:nvSpPr>
        <p:spPr>
          <a:xfrm>
            <a:off x="2207146" y="6257836"/>
            <a:ext cx="7195758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>
                <a:latin typeface="Arial" panose="020B0604020202020204" pitchFamily="34" charset="0"/>
                <a:cs typeface="Arial" panose="020B0604020202020204" pitchFamily="34" charset="0"/>
              </a:rPr>
              <a:t>Supplementary Table 1. </a:t>
            </a:r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P-value of Dunn’s multiple comparisons test. Model performance on Full Test Set. Dice Similarity Coefficient (DSC) Hausdorff distance (HD), Surface Dice similarity coefficient with 2mm margin  (SD 2mm) </a:t>
            </a:r>
          </a:p>
        </p:txBody>
      </p:sp>
    </p:spTree>
    <p:extLst>
      <p:ext uri="{BB962C8B-B14F-4D97-AF65-F5344CB8AC3E}">
        <p14:creationId xmlns:p14="http://schemas.microsoft.com/office/powerpoint/2010/main" val="29048549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>
        <mc:Choice xmlns:a14="http://schemas.microsoft.com/office/drawing/2010/main" Requires="a14">
          <p:graphicFrame>
            <p:nvGraphicFramePr>
              <p:cNvPr id="2" name="Table 1">
                <a:extLst>
                  <a:ext uri="{FF2B5EF4-FFF2-40B4-BE49-F238E27FC236}">
                    <a16:creationId xmlns:a16="http://schemas.microsoft.com/office/drawing/2014/main" id="{65FCBC1F-E6E5-7676-227D-1D0B2602797C}"/>
                  </a:ext>
                </a:extLst>
              </p:cNvPr>
              <p:cNvGraphicFramePr>
                <a:graphicFrameLocks noGrp="1"/>
              </p:cNvGraphicFramePr>
              <p:nvPr/>
            </p:nvGraphicFramePr>
            <p:xfrm>
              <a:off x="1252993" y="803240"/>
              <a:ext cx="9245994" cy="4473575"/>
            </p:xfrm>
            <a:graphic>
              <a:graphicData uri="http://schemas.openxmlformats.org/drawingml/2006/table">
                <a:tbl>
                  <a:tblPr firstRow="1" firstCol="1" bandRow="1">
                    <a:tableStyleId>{5940675A-B579-460E-94D1-54222C63F5DA}</a:tableStyleId>
                  </a:tblPr>
                  <a:tblGrid>
                    <a:gridCol w="942535">
                      <a:extLst>
                        <a:ext uri="{9D8B030D-6E8A-4147-A177-3AD203B41FA5}">
                          <a16:colId xmlns:a16="http://schemas.microsoft.com/office/drawing/2014/main" val="1949119216"/>
                        </a:ext>
                      </a:extLst>
                    </a:gridCol>
                    <a:gridCol w="738554">
                      <a:extLst>
                        <a:ext uri="{9D8B030D-6E8A-4147-A177-3AD203B41FA5}">
                          <a16:colId xmlns:a16="http://schemas.microsoft.com/office/drawing/2014/main" val="834352100"/>
                        </a:ext>
                      </a:extLst>
                    </a:gridCol>
                    <a:gridCol w="840545">
                      <a:extLst>
                        <a:ext uri="{9D8B030D-6E8A-4147-A177-3AD203B41FA5}">
                          <a16:colId xmlns:a16="http://schemas.microsoft.com/office/drawing/2014/main" val="2740627536"/>
                        </a:ext>
                      </a:extLst>
                    </a:gridCol>
                    <a:gridCol w="840545">
                      <a:extLst>
                        <a:ext uri="{9D8B030D-6E8A-4147-A177-3AD203B41FA5}">
                          <a16:colId xmlns:a16="http://schemas.microsoft.com/office/drawing/2014/main" val="392156696"/>
                        </a:ext>
                      </a:extLst>
                    </a:gridCol>
                    <a:gridCol w="840545">
                      <a:extLst>
                        <a:ext uri="{9D8B030D-6E8A-4147-A177-3AD203B41FA5}">
                          <a16:colId xmlns:a16="http://schemas.microsoft.com/office/drawing/2014/main" val="1899616324"/>
                        </a:ext>
                      </a:extLst>
                    </a:gridCol>
                    <a:gridCol w="840545">
                      <a:extLst>
                        <a:ext uri="{9D8B030D-6E8A-4147-A177-3AD203B41FA5}">
                          <a16:colId xmlns:a16="http://schemas.microsoft.com/office/drawing/2014/main" val="4077769823"/>
                        </a:ext>
                      </a:extLst>
                    </a:gridCol>
                    <a:gridCol w="840545">
                      <a:extLst>
                        <a:ext uri="{9D8B030D-6E8A-4147-A177-3AD203B41FA5}">
                          <a16:colId xmlns:a16="http://schemas.microsoft.com/office/drawing/2014/main" val="3058248615"/>
                        </a:ext>
                      </a:extLst>
                    </a:gridCol>
                    <a:gridCol w="840545">
                      <a:extLst>
                        <a:ext uri="{9D8B030D-6E8A-4147-A177-3AD203B41FA5}">
                          <a16:colId xmlns:a16="http://schemas.microsoft.com/office/drawing/2014/main" val="771218125"/>
                        </a:ext>
                      </a:extLst>
                    </a:gridCol>
                    <a:gridCol w="840545">
                      <a:extLst>
                        <a:ext uri="{9D8B030D-6E8A-4147-A177-3AD203B41FA5}">
                          <a16:colId xmlns:a16="http://schemas.microsoft.com/office/drawing/2014/main" val="137810377"/>
                        </a:ext>
                      </a:extLst>
                    </a:gridCol>
                    <a:gridCol w="840545">
                      <a:extLst>
                        <a:ext uri="{9D8B030D-6E8A-4147-A177-3AD203B41FA5}">
                          <a16:colId xmlns:a16="http://schemas.microsoft.com/office/drawing/2014/main" val="274157669"/>
                        </a:ext>
                      </a:extLst>
                    </a:gridCol>
                    <a:gridCol w="840545">
                      <a:extLst>
                        <a:ext uri="{9D8B030D-6E8A-4147-A177-3AD203B41FA5}">
                          <a16:colId xmlns:a16="http://schemas.microsoft.com/office/drawing/2014/main" val="274360666"/>
                        </a:ext>
                      </a:extLst>
                    </a:gridCol>
                  </a:tblGrid>
                  <a:tr h="185420">
                    <a:tc rowSpan="2">
                      <a:txBody>
                        <a:bodyPr/>
                        <a:lstStyle/>
                        <a:p>
                          <a:pPr marL="0" marR="0" algn="l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 </a:t>
                          </a:r>
                        </a:p>
                        <a:p>
                          <a:pPr marL="0" marR="0" algn="l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 </a:t>
                          </a:r>
                        </a:p>
                      </a:txBody>
                      <a:tcPr marL="68580" marR="68580" marT="0" marB="0">
                        <a:solidFill>
                          <a:schemeClr val="bg2"/>
                        </a:solidFill>
                      </a:tcPr>
                    </a:tc>
                    <a:tc gridSpan="7">
                      <a:txBody>
                        <a:bodyPr/>
                        <a:lstStyle/>
                        <a:p>
                          <a:pPr algn="ctr"/>
                          <a:r>
                            <a:rPr lang="en-US" sz="1200" b="1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Mixed-Curation</a:t>
                          </a:r>
                          <a:r>
                            <a:rPr lang="en-US" sz="120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 </a:t>
                          </a: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models</a:t>
                          </a:r>
                          <a:endParaRPr lang="en-US" sz="120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gridSpan="3"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Highly curated models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extLst>
                      <a:ext uri="{0D108BD9-81ED-4DB2-BD59-A6C34878D82A}">
                        <a16:rowId xmlns:a16="http://schemas.microsoft.com/office/drawing/2014/main" val="192860897"/>
                      </a:ext>
                    </a:extLst>
                  </a:tr>
                  <a:tr h="370840">
                    <a:tc vMerge="1">
                      <a:txBody>
                        <a:bodyPr/>
                        <a:lstStyle/>
                        <a:p>
                          <a:pPr marL="0" marR="0" algn="l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+mn-lt"/>
                              <a:ea typeface="+mn-ea"/>
                              <a:cs typeface="+mn-cs"/>
                            </a:rPr>
                            <a:t> </a:t>
                          </a: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56-scan 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142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284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710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1420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2130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2840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56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142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244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3026451276"/>
                      </a:ext>
                    </a:extLst>
                  </a:tr>
                  <a:tr h="189865">
                    <a:tc gridSpan="11">
                      <a:txBody>
                        <a:bodyPr/>
                        <a:lstStyle/>
                        <a:p>
                          <a:pPr marL="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Slice DSC – Full Test Set</a:t>
                          </a:r>
                        </a:p>
                      </a:txBody>
                      <a:tcPr marL="68580" marR="68580" marT="0" marB="0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3137752485"/>
                      </a:ext>
                    </a:extLst>
                  </a:tr>
                  <a:tr h="185420">
                    <a:tc>
                      <a:txBody>
                        <a:bodyPr/>
                        <a:lstStyle/>
                        <a:p>
                          <a:pPr marL="11430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Versus minimally curated 56-scan model</a:t>
                          </a: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sz="1200" b="1" kern="100" dirty="0">
                              <a:effectLst/>
                              <a:latin typeface="Arial" panose="020B0604020202020204" pitchFamily="34" charset="0"/>
                              <a:ea typeface="Cambria Math" panose="02040503050406030204" pitchFamily="18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lt;  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00" cap="none" spc="0" normalizeH="0" baseline="0" noProof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lt;  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00" cap="none" spc="0" normalizeH="0" baseline="0" noProof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lt;  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00" cap="none" spc="0" normalizeH="0" baseline="0" noProof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lt;  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00" cap="none" spc="0" normalizeH="0" baseline="0" noProof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lt;  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00" cap="none" spc="0" normalizeH="0" baseline="0" noProof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lt;  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00" cap="none" spc="0" normalizeH="0" baseline="0" noProof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lt;  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00" cap="none" spc="0" normalizeH="0" baseline="0" noProof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lt;  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00" cap="none" spc="0" normalizeH="0" baseline="0" noProof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lt;  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00" cap="none" spc="0" normalizeH="0" baseline="0" noProof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4129130750"/>
                      </a:ext>
                    </a:extLst>
                  </a:tr>
                  <a:tr h="185420">
                    <a:tc>
                      <a:txBody>
                        <a:bodyPr/>
                        <a:lstStyle/>
                        <a:p>
                          <a:pPr marL="11430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Versus highly curated 244-scan model</a:t>
                          </a: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lt;  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00" cap="none" spc="0" normalizeH="0" baseline="0" noProof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lt;  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00" cap="none" spc="0" normalizeH="0" baseline="0" noProof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lt;  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00" cap="none" spc="0" normalizeH="0" baseline="0" noProof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lt;  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00" cap="none" spc="0" normalizeH="0" baseline="0" noProof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lt;  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00" cap="none" spc="0" normalizeH="0" baseline="0" noProof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𝟎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𝟒𝟖𝟑𝟑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00" cap="none" spc="0" normalizeH="0" baseline="0" noProof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b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g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lt;  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00" cap="none" spc="0" normalizeH="0" baseline="0" noProof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𝟎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𝟎𝟏𝟒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00" cap="none" spc="0" normalizeH="0" baseline="0" noProof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sz="1200" b="1" kern="100">
                              <a:effectLst/>
                              <a:latin typeface="Arial" panose="020B0604020202020204" pitchFamily="34" charset="0"/>
                              <a:ea typeface="Cambria Math" panose="02040503050406030204" pitchFamily="18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3615192787"/>
                      </a:ext>
                    </a:extLst>
                  </a:tr>
                  <a:tr h="185420">
                    <a:tc gridSpan="11">
                      <a:txBody>
                        <a:bodyPr/>
                        <a:lstStyle/>
                        <a:p>
                          <a:pPr marL="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Slice DSC – MICCAI Set</a:t>
                          </a:r>
                        </a:p>
                      </a:txBody>
                      <a:tcPr marL="68580" marR="68580" marT="0" marB="0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1786108808"/>
                      </a:ext>
                    </a:extLst>
                  </a:tr>
                  <a:tr h="185420">
                    <a:tc>
                      <a:txBody>
                        <a:bodyPr/>
                        <a:lstStyle/>
                        <a:p>
                          <a:pPr marL="11430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Versus minimally curated 56-scan model</a:t>
                          </a: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sz="1200" b="1" kern="100">
                              <a:effectLst/>
                              <a:latin typeface="Arial" panose="020B0604020202020204" pitchFamily="34" charset="0"/>
                              <a:ea typeface="Cambria Math" panose="02040503050406030204" pitchFamily="18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lt;  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lt;  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00" cap="none" spc="0" normalizeH="0" baseline="0" noProof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lt;  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00" cap="none" spc="0" normalizeH="0" baseline="0" noProof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lt;  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00" cap="none" spc="0" normalizeH="0" baseline="0" noProof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lt;  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00" cap="none" spc="0" normalizeH="0" baseline="0" noProof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lt;  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00" cap="none" spc="0" normalizeH="0" baseline="0" noProof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lt;  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00" cap="none" spc="0" normalizeH="0" baseline="0" noProof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lt;  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00" cap="none" spc="0" normalizeH="0" baseline="0" noProof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lt;  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00" cap="none" spc="0" normalizeH="0" baseline="0" noProof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2757718277"/>
                      </a:ext>
                    </a:extLst>
                  </a:tr>
                  <a:tr h="185420">
                    <a:tc>
                      <a:txBody>
                        <a:bodyPr/>
                        <a:lstStyle/>
                        <a:p>
                          <a:pPr marL="11430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Versus highly curated 244-scan model</a:t>
                          </a: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lt;  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00" cap="none" spc="0" normalizeH="0" baseline="0" noProof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b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g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lang="en-US" sz="1200" b="1" i="0" u="none" strike="noStrike" dirty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𝟎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𝟎𝟏𝟐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00" cap="none" spc="0" normalizeH="0" baseline="0" noProof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lt;  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00" cap="none" spc="0" normalizeH="0" baseline="0" noProof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𝟎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00" cap="none" spc="0" normalizeH="0" baseline="0" noProof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b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g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lt;  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00" cap="none" spc="0" normalizeH="0" baseline="0" noProof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b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𝟔𝟓𝟗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sz="1200" b="1" kern="100" dirty="0">
                              <a:effectLst/>
                              <a:latin typeface="Arial" panose="020B0604020202020204" pitchFamily="34" charset="0"/>
                              <a:ea typeface="Cambria Math" panose="02040503050406030204" pitchFamily="18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897063501"/>
                      </a:ext>
                    </a:extLst>
                  </a:tr>
                </a:tbl>
              </a:graphicData>
            </a:graphic>
          </p:graphicFrame>
        </mc:Choice>
        <mc:Fallback>
          <p:graphicFrame>
            <p:nvGraphicFramePr>
              <p:cNvPr id="2" name="Table 1">
                <a:extLst>
                  <a:ext uri="{FF2B5EF4-FFF2-40B4-BE49-F238E27FC236}">
                    <a16:creationId xmlns:a16="http://schemas.microsoft.com/office/drawing/2014/main" id="{65FCBC1F-E6E5-7676-227D-1D0B2602797C}"/>
                  </a:ext>
                </a:extLst>
              </p:cNvPr>
              <p:cNvGraphicFramePr>
                <a:graphicFrameLocks noGrp="1"/>
              </p:cNvGraphicFramePr>
              <p:nvPr/>
            </p:nvGraphicFramePr>
            <p:xfrm>
              <a:off x="1252993" y="803240"/>
              <a:ext cx="9245994" cy="4473575"/>
            </p:xfrm>
            <a:graphic>
              <a:graphicData uri="http://schemas.openxmlformats.org/drawingml/2006/table">
                <a:tbl>
                  <a:tblPr firstRow="1" firstCol="1" bandRow="1">
                    <a:tableStyleId>{5940675A-B579-460E-94D1-54222C63F5DA}</a:tableStyleId>
                  </a:tblPr>
                  <a:tblGrid>
                    <a:gridCol w="942535">
                      <a:extLst>
                        <a:ext uri="{9D8B030D-6E8A-4147-A177-3AD203B41FA5}">
                          <a16:colId xmlns:a16="http://schemas.microsoft.com/office/drawing/2014/main" val="1949119216"/>
                        </a:ext>
                      </a:extLst>
                    </a:gridCol>
                    <a:gridCol w="738554">
                      <a:extLst>
                        <a:ext uri="{9D8B030D-6E8A-4147-A177-3AD203B41FA5}">
                          <a16:colId xmlns:a16="http://schemas.microsoft.com/office/drawing/2014/main" val="834352100"/>
                        </a:ext>
                      </a:extLst>
                    </a:gridCol>
                    <a:gridCol w="840545">
                      <a:extLst>
                        <a:ext uri="{9D8B030D-6E8A-4147-A177-3AD203B41FA5}">
                          <a16:colId xmlns:a16="http://schemas.microsoft.com/office/drawing/2014/main" val="2740627536"/>
                        </a:ext>
                      </a:extLst>
                    </a:gridCol>
                    <a:gridCol w="840545">
                      <a:extLst>
                        <a:ext uri="{9D8B030D-6E8A-4147-A177-3AD203B41FA5}">
                          <a16:colId xmlns:a16="http://schemas.microsoft.com/office/drawing/2014/main" val="392156696"/>
                        </a:ext>
                      </a:extLst>
                    </a:gridCol>
                    <a:gridCol w="840545">
                      <a:extLst>
                        <a:ext uri="{9D8B030D-6E8A-4147-A177-3AD203B41FA5}">
                          <a16:colId xmlns:a16="http://schemas.microsoft.com/office/drawing/2014/main" val="1899616324"/>
                        </a:ext>
                      </a:extLst>
                    </a:gridCol>
                    <a:gridCol w="840545">
                      <a:extLst>
                        <a:ext uri="{9D8B030D-6E8A-4147-A177-3AD203B41FA5}">
                          <a16:colId xmlns:a16="http://schemas.microsoft.com/office/drawing/2014/main" val="4077769823"/>
                        </a:ext>
                      </a:extLst>
                    </a:gridCol>
                    <a:gridCol w="840545">
                      <a:extLst>
                        <a:ext uri="{9D8B030D-6E8A-4147-A177-3AD203B41FA5}">
                          <a16:colId xmlns:a16="http://schemas.microsoft.com/office/drawing/2014/main" val="3058248615"/>
                        </a:ext>
                      </a:extLst>
                    </a:gridCol>
                    <a:gridCol w="840545">
                      <a:extLst>
                        <a:ext uri="{9D8B030D-6E8A-4147-A177-3AD203B41FA5}">
                          <a16:colId xmlns:a16="http://schemas.microsoft.com/office/drawing/2014/main" val="771218125"/>
                        </a:ext>
                      </a:extLst>
                    </a:gridCol>
                    <a:gridCol w="840545">
                      <a:extLst>
                        <a:ext uri="{9D8B030D-6E8A-4147-A177-3AD203B41FA5}">
                          <a16:colId xmlns:a16="http://schemas.microsoft.com/office/drawing/2014/main" val="137810377"/>
                        </a:ext>
                      </a:extLst>
                    </a:gridCol>
                    <a:gridCol w="840545">
                      <a:extLst>
                        <a:ext uri="{9D8B030D-6E8A-4147-A177-3AD203B41FA5}">
                          <a16:colId xmlns:a16="http://schemas.microsoft.com/office/drawing/2014/main" val="274157669"/>
                        </a:ext>
                      </a:extLst>
                    </a:gridCol>
                    <a:gridCol w="840545">
                      <a:extLst>
                        <a:ext uri="{9D8B030D-6E8A-4147-A177-3AD203B41FA5}">
                          <a16:colId xmlns:a16="http://schemas.microsoft.com/office/drawing/2014/main" val="274360666"/>
                        </a:ext>
                      </a:extLst>
                    </a:gridCol>
                  </a:tblGrid>
                  <a:tr h="185420">
                    <a:tc rowSpan="2">
                      <a:txBody>
                        <a:bodyPr/>
                        <a:lstStyle/>
                        <a:p>
                          <a:pPr marL="0" marR="0" algn="l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 </a:t>
                          </a:r>
                        </a:p>
                        <a:p>
                          <a:pPr marL="0" marR="0" algn="l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 </a:t>
                          </a:r>
                        </a:p>
                      </a:txBody>
                      <a:tcPr marL="68580" marR="68580" marT="0" marB="0">
                        <a:solidFill>
                          <a:schemeClr val="bg2"/>
                        </a:solidFill>
                      </a:tcPr>
                    </a:tc>
                    <a:tc gridSpan="7">
                      <a:txBody>
                        <a:bodyPr/>
                        <a:lstStyle/>
                        <a:p>
                          <a:pPr algn="ctr"/>
                          <a:r>
                            <a:rPr lang="en-US" sz="1200" b="1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Mixed-Curation</a:t>
                          </a:r>
                          <a:r>
                            <a:rPr lang="en-US" sz="120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 </a:t>
                          </a: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models</a:t>
                          </a:r>
                          <a:endParaRPr lang="en-US" sz="120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gridSpan="3"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Highly curated models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extLst>
                      <a:ext uri="{0D108BD9-81ED-4DB2-BD59-A6C34878D82A}">
                        <a16:rowId xmlns:a16="http://schemas.microsoft.com/office/drawing/2014/main" val="192860897"/>
                      </a:ext>
                    </a:extLst>
                  </a:tr>
                  <a:tr h="377190">
                    <a:tc vMerge="1">
                      <a:txBody>
                        <a:bodyPr/>
                        <a:lstStyle/>
                        <a:p>
                          <a:pPr marL="0" marR="0" algn="l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+mn-lt"/>
                              <a:ea typeface="+mn-ea"/>
                              <a:cs typeface="+mn-cs"/>
                            </a:rPr>
                            <a:t> </a:t>
                          </a: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56-scan 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142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284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710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1420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2130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2840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56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142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244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3026451276"/>
                      </a:ext>
                    </a:extLst>
                  </a:tr>
                  <a:tr h="189865">
                    <a:tc gridSpan="11">
                      <a:txBody>
                        <a:bodyPr/>
                        <a:lstStyle/>
                        <a:p>
                          <a:pPr marL="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Slice DSC – Full Test Set</a:t>
                          </a:r>
                        </a:p>
                      </a:txBody>
                      <a:tcPr marL="68580" marR="68580" marT="0" marB="0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3137752485"/>
                      </a:ext>
                    </a:extLst>
                  </a:tr>
                  <a:tr h="883920">
                    <a:tc>
                      <a:txBody>
                        <a:bodyPr/>
                        <a:lstStyle/>
                        <a:p>
                          <a:pPr marL="11430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Versus minimally curated 56-scan model</a:t>
                          </a: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sz="1200" b="1" kern="100" dirty="0">
                              <a:effectLst/>
                              <a:latin typeface="Arial" panose="020B0604020202020204" pitchFamily="34" charset="0"/>
                              <a:ea typeface="Cambria Math" panose="02040503050406030204" pitchFamily="18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203030" t="-90000" r="-806061" b="-33000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303030" t="-90000" r="-706061" b="-33000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403030" t="-90000" r="-606061" b="-33000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495522" t="-90000" r="-497015" b="-33000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604545" t="-90000" r="-404545" b="-33000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704545" t="-90000" r="-304545" b="-33000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804545" t="-90000" r="-204545" b="-33000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891045" t="-90000" r="-101493" b="-33000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1006061" t="-90000" r="-3030" b="-330000"/>
                          </a:stretch>
                        </a:blipFill>
                      </a:tcPr>
                    </a:tc>
                    <a:extLst>
                      <a:ext uri="{0D108BD9-81ED-4DB2-BD59-A6C34878D82A}">
                        <a16:rowId xmlns:a16="http://schemas.microsoft.com/office/drawing/2014/main" val="4129130750"/>
                      </a:ext>
                    </a:extLst>
                  </a:tr>
                  <a:tr h="883920">
                    <a:tc>
                      <a:txBody>
                        <a:bodyPr/>
                        <a:lstStyle/>
                        <a:p>
                          <a:pPr marL="11430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Versus highly curated 244-scan model</a:t>
                          </a: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127119" t="-190000" r="-1013559" b="-23000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203030" t="-190000" r="-806061" b="-23000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303030" t="-190000" r="-706061" b="-23000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403030" t="-190000" r="-606061" b="-23000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495522" t="-190000" r="-497015" b="-23000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604545" t="-190000" r="-404545" b="-23000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704545" t="-190000" r="-304545" b="-23000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804545" t="-190000" r="-204545" b="-23000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891045" t="-190000" r="-101493" b="-23000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sz="1200" b="1" kern="100">
                              <a:effectLst/>
                              <a:latin typeface="Arial" panose="020B0604020202020204" pitchFamily="34" charset="0"/>
                              <a:ea typeface="Cambria Math" panose="02040503050406030204" pitchFamily="18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3615192787"/>
                      </a:ext>
                    </a:extLst>
                  </a:tr>
                  <a:tr h="185420">
                    <a:tc gridSpan="11">
                      <a:txBody>
                        <a:bodyPr/>
                        <a:lstStyle/>
                        <a:p>
                          <a:pPr marL="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Slice DSC – MICCAI Set</a:t>
                          </a:r>
                        </a:p>
                      </a:txBody>
                      <a:tcPr marL="68580" marR="68580" marT="0" marB="0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1786108808"/>
                      </a:ext>
                    </a:extLst>
                  </a:tr>
                  <a:tr h="883920">
                    <a:tc>
                      <a:txBody>
                        <a:bodyPr/>
                        <a:lstStyle/>
                        <a:p>
                          <a:pPr marL="11430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Versus minimally curated 56-scan model</a:t>
                          </a: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sz="1200" b="1" kern="100">
                              <a:effectLst/>
                              <a:latin typeface="Arial" panose="020B0604020202020204" pitchFamily="34" charset="0"/>
                              <a:ea typeface="Cambria Math" panose="02040503050406030204" pitchFamily="18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203030" t="-315942" r="-806061" b="-111594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303030" t="-315942" r="-706061" b="-111594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403030" t="-315942" r="-606061" b="-111594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495522" t="-315942" r="-497015" b="-111594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604545" t="-315942" r="-404545" b="-111594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704545" t="-315942" r="-304545" b="-111594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804545" t="-315942" r="-204545" b="-111594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891045" t="-315942" r="-101493" b="-111594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1006061" t="-315942" r="-3030" b="-111594"/>
                          </a:stretch>
                        </a:blipFill>
                      </a:tcPr>
                    </a:tc>
                    <a:extLst>
                      <a:ext uri="{0D108BD9-81ED-4DB2-BD59-A6C34878D82A}">
                        <a16:rowId xmlns:a16="http://schemas.microsoft.com/office/drawing/2014/main" val="2757718277"/>
                      </a:ext>
                    </a:extLst>
                  </a:tr>
                  <a:tr h="883920">
                    <a:tc>
                      <a:txBody>
                        <a:bodyPr/>
                        <a:lstStyle/>
                        <a:p>
                          <a:pPr marL="11430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Versus highly curated 244-scan model</a:t>
                          </a: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127119" t="-410000" r="-1013559" b="-1000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203030" t="-410000" r="-806061" b="-1000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303030" t="-410000" r="-706061" b="-1000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403030" t="-410000" r="-606061" b="-1000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495522" t="-410000" r="-497015" b="-1000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604545" t="-410000" r="-404545" b="-1000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704545" t="-410000" r="-304545" b="-1000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804545" t="-410000" r="-204545" b="-1000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891045" t="-410000" r="-101493" b="-1000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sz="1200" b="1" kern="100" dirty="0">
                              <a:effectLst/>
                              <a:latin typeface="Arial" panose="020B0604020202020204" pitchFamily="34" charset="0"/>
                              <a:ea typeface="Cambria Math" panose="02040503050406030204" pitchFamily="18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897063501"/>
                      </a:ext>
                    </a:extLst>
                  </a:tr>
                </a:tbl>
              </a:graphicData>
            </a:graphic>
          </p:graphicFrame>
        </mc:Fallback>
      </mc:AlternateContent>
      <p:sp>
        <p:nvSpPr>
          <p:cNvPr id="3" name="TextBox 2">
            <a:extLst>
              <a:ext uri="{FF2B5EF4-FFF2-40B4-BE49-F238E27FC236}">
                <a16:creationId xmlns:a16="http://schemas.microsoft.com/office/drawing/2014/main" id="{849C3130-700C-4272-0850-0B85317611CB}"/>
              </a:ext>
            </a:extLst>
          </p:cNvPr>
          <p:cNvSpPr txBox="1"/>
          <p:nvPr/>
        </p:nvSpPr>
        <p:spPr>
          <a:xfrm>
            <a:off x="2278111" y="6427113"/>
            <a:ext cx="719575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2.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-value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f Dunn’s multiple comparisons test. Mode performance on Slice DSC for the Full Test Set and BCTV Set. Dice Similarity Coefficient (DSC)</a:t>
            </a:r>
          </a:p>
        </p:txBody>
      </p:sp>
    </p:spTree>
    <p:extLst>
      <p:ext uri="{BB962C8B-B14F-4D97-AF65-F5344CB8AC3E}">
        <p14:creationId xmlns:p14="http://schemas.microsoft.com/office/powerpoint/2010/main" val="6622105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>
        <mc:Choice xmlns:a14="http://schemas.microsoft.com/office/drawing/2010/main" Requires="a14">
          <p:graphicFrame>
            <p:nvGraphicFramePr>
              <p:cNvPr id="2" name="Table 1">
                <a:extLst>
                  <a:ext uri="{FF2B5EF4-FFF2-40B4-BE49-F238E27FC236}">
                    <a16:creationId xmlns:a16="http://schemas.microsoft.com/office/drawing/2014/main" id="{65FCBC1F-E6E5-7676-227D-1D0B2602797C}"/>
                  </a:ext>
                </a:extLst>
              </p:cNvPr>
              <p:cNvGraphicFramePr>
                <a:graphicFrameLocks noGrp="1"/>
              </p:cNvGraphicFramePr>
              <p:nvPr/>
            </p:nvGraphicFramePr>
            <p:xfrm>
              <a:off x="662189" y="353711"/>
              <a:ext cx="10467358" cy="6146976"/>
            </p:xfrm>
            <a:graphic>
              <a:graphicData uri="http://schemas.openxmlformats.org/drawingml/2006/table">
                <a:tbl>
                  <a:tblPr firstRow="1" firstCol="1" bandRow="1">
                    <a:tableStyleId>{5940675A-B579-460E-94D1-54222C63F5DA}</a:tableStyleId>
                  </a:tblPr>
                  <a:tblGrid>
                    <a:gridCol w="1067041">
                      <a:extLst>
                        <a:ext uri="{9D8B030D-6E8A-4147-A177-3AD203B41FA5}">
                          <a16:colId xmlns:a16="http://schemas.microsoft.com/office/drawing/2014/main" val="1949119216"/>
                        </a:ext>
                      </a:extLst>
                    </a:gridCol>
                    <a:gridCol w="836115">
                      <a:extLst>
                        <a:ext uri="{9D8B030D-6E8A-4147-A177-3AD203B41FA5}">
                          <a16:colId xmlns:a16="http://schemas.microsoft.com/office/drawing/2014/main" val="834352100"/>
                        </a:ext>
                      </a:extLst>
                    </a:gridCol>
                    <a:gridCol w="951578">
                      <a:extLst>
                        <a:ext uri="{9D8B030D-6E8A-4147-A177-3AD203B41FA5}">
                          <a16:colId xmlns:a16="http://schemas.microsoft.com/office/drawing/2014/main" val="2740627536"/>
                        </a:ext>
                      </a:extLst>
                    </a:gridCol>
                    <a:gridCol w="951578">
                      <a:extLst>
                        <a:ext uri="{9D8B030D-6E8A-4147-A177-3AD203B41FA5}">
                          <a16:colId xmlns:a16="http://schemas.microsoft.com/office/drawing/2014/main" val="392156696"/>
                        </a:ext>
                      </a:extLst>
                    </a:gridCol>
                    <a:gridCol w="951578">
                      <a:extLst>
                        <a:ext uri="{9D8B030D-6E8A-4147-A177-3AD203B41FA5}">
                          <a16:colId xmlns:a16="http://schemas.microsoft.com/office/drawing/2014/main" val="1899616324"/>
                        </a:ext>
                      </a:extLst>
                    </a:gridCol>
                    <a:gridCol w="951578">
                      <a:extLst>
                        <a:ext uri="{9D8B030D-6E8A-4147-A177-3AD203B41FA5}">
                          <a16:colId xmlns:a16="http://schemas.microsoft.com/office/drawing/2014/main" val="4077769823"/>
                        </a:ext>
                      </a:extLst>
                    </a:gridCol>
                    <a:gridCol w="951578">
                      <a:extLst>
                        <a:ext uri="{9D8B030D-6E8A-4147-A177-3AD203B41FA5}">
                          <a16:colId xmlns:a16="http://schemas.microsoft.com/office/drawing/2014/main" val="3058248615"/>
                        </a:ext>
                      </a:extLst>
                    </a:gridCol>
                    <a:gridCol w="951578">
                      <a:extLst>
                        <a:ext uri="{9D8B030D-6E8A-4147-A177-3AD203B41FA5}">
                          <a16:colId xmlns:a16="http://schemas.microsoft.com/office/drawing/2014/main" val="771218125"/>
                        </a:ext>
                      </a:extLst>
                    </a:gridCol>
                    <a:gridCol w="951578">
                      <a:extLst>
                        <a:ext uri="{9D8B030D-6E8A-4147-A177-3AD203B41FA5}">
                          <a16:colId xmlns:a16="http://schemas.microsoft.com/office/drawing/2014/main" val="137810377"/>
                        </a:ext>
                      </a:extLst>
                    </a:gridCol>
                    <a:gridCol w="951578">
                      <a:extLst>
                        <a:ext uri="{9D8B030D-6E8A-4147-A177-3AD203B41FA5}">
                          <a16:colId xmlns:a16="http://schemas.microsoft.com/office/drawing/2014/main" val="274157669"/>
                        </a:ext>
                      </a:extLst>
                    </a:gridCol>
                    <a:gridCol w="951578">
                      <a:extLst>
                        <a:ext uri="{9D8B030D-6E8A-4147-A177-3AD203B41FA5}">
                          <a16:colId xmlns:a16="http://schemas.microsoft.com/office/drawing/2014/main" val="274360666"/>
                        </a:ext>
                      </a:extLst>
                    </a:gridCol>
                  </a:tblGrid>
                  <a:tr h="171095">
                    <a:tc rowSpan="2">
                      <a:txBody>
                        <a:bodyPr/>
                        <a:lstStyle/>
                        <a:p>
                          <a:pPr marL="0" marR="0" algn="l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 </a:t>
                          </a:r>
                        </a:p>
                        <a:p>
                          <a:pPr marL="0" marR="0" algn="l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 </a:t>
                          </a:r>
                        </a:p>
                      </a:txBody>
                      <a:tcPr marL="68580" marR="68580" marT="0" marB="0">
                        <a:solidFill>
                          <a:schemeClr val="bg2"/>
                        </a:solidFill>
                      </a:tcPr>
                    </a:tc>
                    <a:tc gridSpan="7">
                      <a:txBody>
                        <a:bodyPr/>
                        <a:lstStyle/>
                        <a:p>
                          <a:pPr algn="ctr"/>
                          <a:r>
                            <a:rPr lang="en-US" sz="1200" b="1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Mixed-Curation</a:t>
                          </a:r>
                          <a:r>
                            <a:rPr lang="en-US" sz="120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 </a:t>
                          </a: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models</a:t>
                          </a:r>
                          <a:endParaRPr lang="en-US" sz="120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gridSpan="3"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Highly curated models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extLst>
                      <a:ext uri="{0D108BD9-81ED-4DB2-BD59-A6C34878D82A}">
                        <a16:rowId xmlns:a16="http://schemas.microsoft.com/office/drawing/2014/main" val="192860897"/>
                      </a:ext>
                    </a:extLst>
                  </a:tr>
                  <a:tr h="348050">
                    <a:tc vMerge="1">
                      <a:txBody>
                        <a:bodyPr/>
                        <a:lstStyle/>
                        <a:p>
                          <a:pPr marL="0" marR="0" algn="l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+mn-lt"/>
                              <a:ea typeface="+mn-ea"/>
                              <a:cs typeface="+mn-cs"/>
                            </a:rPr>
                            <a:t> </a:t>
                          </a: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56-scan 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142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284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710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1420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2130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2840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56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142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244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3026451276"/>
                      </a:ext>
                    </a:extLst>
                  </a:tr>
                  <a:tr h="175197">
                    <a:tc gridSpan="11">
                      <a:txBody>
                        <a:bodyPr/>
                        <a:lstStyle/>
                        <a:p>
                          <a:pPr marL="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DSC</a:t>
                          </a:r>
                        </a:p>
                      </a:txBody>
                      <a:tcPr marL="68580" marR="68580" marT="0" marB="0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3137752485"/>
                      </a:ext>
                    </a:extLst>
                  </a:tr>
                  <a:tr h="815633">
                    <a:tc>
                      <a:txBody>
                        <a:bodyPr/>
                        <a:lstStyle/>
                        <a:p>
                          <a:pPr marL="11430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Versus minimally curated 56-scan model</a:t>
                          </a: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sz="1200" b="1" kern="100">
                              <a:effectLst/>
                              <a:latin typeface="Arial" panose="020B0604020202020204" pitchFamily="34" charset="0"/>
                              <a:ea typeface="Cambria Math" panose="02040503050406030204" pitchFamily="18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𝟓𝟎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Arial" panose="020B0604020202020204" pitchFamily="34" charset="0"/>
                                  </a:rPr>
                                  <m:t>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Arial" panose="020B0604020202020204" pitchFamily="34" charset="0"/>
                                  </a:rPr>
                                  <m:t>𝟎𝟑𝟗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Arial" panose="020B0604020202020204" pitchFamily="34" charset="0"/>
                                  </a:rPr>
                                  <m:t>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Arial" panose="020B0604020202020204" pitchFamily="34" charset="0"/>
                                  </a:rPr>
                                  <m:t>𝟎𝟎𝟐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Arial" panose="020B0604020202020204" pitchFamily="34" charset="0"/>
                                  </a:rPr>
                                  <m:t>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Arial" panose="020B0604020202020204" pitchFamily="34" charset="0"/>
                                  </a:rPr>
                                  <m:t>𝟎𝟎𝟖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 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Arial" panose="020B0604020202020204" pitchFamily="34" charset="0"/>
                                  </a:rPr>
                                  <m:t>&g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Arial" panose="020B0604020202020204" pitchFamily="34" charset="0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 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 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4129130750"/>
                      </a:ext>
                    </a:extLst>
                  </a:tr>
                  <a:tr h="815633">
                    <a:tc>
                      <a:txBody>
                        <a:bodyPr/>
                        <a:lstStyle/>
                        <a:p>
                          <a:pPr marL="11430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Versus highly curated 244-scan model</a:t>
                          </a: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lt;  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b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gt;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200" cap="none" spc="0" normalizeH="0" baseline="0" noProof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b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gt;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200" cap="none" spc="0" normalizeH="0" baseline="0" noProof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b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gt;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200" cap="none" spc="0" normalizeH="0" baseline="0" noProof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b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gt;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200" cap="none" spc="0" normalizeH="0" baseline="0" noProof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b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gt;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200" cap="none" spc="0" normalizeH="0" baseline="0" noProof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b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gt;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200" cap="none" spc="0" normalizeH="0" baseline="0" noProof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𝟒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b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gt;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200" cap="none" spc="0" normalizeH="0" baseline="0" noProof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sz="1200" b="1" kern="100">
                              <a:effectLst/>
                              <a:latin typeface="Arial" panose="020B0604020202020204" pitchFamily="34" charset="0"/>
                              <a:ea typeface="Cambria Math" panose="02040503050406030204" pitchFamily="18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3615192787"/>
                      </a:ext>
                    </a:extLst>
                  </a:tr>
                  <a:tr h="171095">
                    <a:tc gridSpan="11">
                      <a:txBody>
                        <a:bodyPr/>
                        <a:lstStyle/>
                        <a:p>
                          <a:pPr marL="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Hausdorff distance, 95th percentile</a:t>
                          </a:r>
                        </a:p>
                      </a:txBody>
                      <a:tcPr marL="68580" marR="68580" marT="0" marB="0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1293607918"/>
                      </a:ext>
                    </a:extLst>
                  </a:tr>
                  <a:tr h="815633">
                    <a:tc>
                      <a:txBody>
                        <a:bodyPr/>
                        <a:lstStyle/>
                        <a:p>
                          <a:pPr marL="11430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Versus minimally curated 56-scan model</a:t>
                          </a: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ctr" rtl="0" fontAlgn="b"/>
                          <a:r>
                            <a:rPr lang="en-US" sz="1200" b="1" i="0" u="none" strike="noStrike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Cambria Math" panose="02040503050406030204" pitchFamily="18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b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gt;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200" cap="none" spc="0" normalizeH="0" baseline="0" noProof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b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gt;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200" cap="none" spc="0" normalizeH="0" baseline="0" noProof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Arial" panose="020B0604020202020204" pitchFamily="34" charset="0"/>
                                  </a:rPr>
                                  <m:t>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Arial" panose="020B0604020202020204" pitchFamily="34" charset="0"/>
                                  </a:rPr>
                                  <m:t>𝟎𝟐𝟑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Arial" panose="020B0604020202020204" pitchFamily="34" charset="0"/>
                                  </a:rPr>
                                  <m:t>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Arial" panose="020B0604020202020204" pitchFamily="34" charset="0"/>
                                  </a:rPr>
                                  <m:t>𝟎𝟔𝟓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Arial" panose="020B0604020202020204" pitchFamily="34" charset="0"/>
                                  </a:rPr>
                                  <m:t>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Arial" panose="020B0604020202020204" pitchFamily="34" charset="0"/>
                                  </a:rPr>
                                  <m:t>𝟎𝟑𝟒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Arial" panose="020B0604020202020204" pitchFamily="34" charset="0"/>
                                  </a:rPr>
                                  <m:t>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Arial" panose="020B0604020202020204" pitchFamily="34" charset="0"/>
                                  </a:rPr>
                                  <m:t>𝟎𝟖𝟗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b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gt;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200" cap="none" spc="0" normalizeH="0" baseline="0" noProof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b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gt;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200" cap="none" spc="0" normalizeH="0" baseline="0" noProof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u="none" strike="noStrike" smtClean="0">
                                    <a:solidFill>
                                      <a:srgbClr val="000000"/>
                                    </a:solidFill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</m:t>
                                </m:r>
                                <m:r>
                                  <a:rPr lang="en-US" sz="1200" b="1" i="1" u="none" strike="noStrike" smtClean="0">
                                    <a:solidFill>
                                      <a:srgbClr val="000000"/>
                                    </a:solidFill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.</m:t>
                                </m:r>
                                <m:r>
                                  <a:rPr lang="en-US" sz="1200" b="1" i="1" u="none" strike="noStrike" smtClean="0">
                                    <a:solidFill>
                                      <a:srgbClr val="000000"/>
                                    </a:solidFill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𝟒𝟒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1678689836"/>
                      </a:ext>
                    </a:extLst>
                  </a:tr>
                  <a:tr h="815633">
                    <a:tc>
                      <a:txBody>
                        <a:bodyPr/>
                        <a:lstStyle/>
                        <a:p>
                          <a:pPr marL="11430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Versus highly curated 244-scan model</a:t>
                          </a: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ctr" rtl="0" fontAlgn="ctr"/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u="none" strike="noStrike" smtClean="0">
                                    <a:solidFill>
                                      <a:srgbClr val="000000"/>
                                    </a:solidFill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</m:t>
                                </m:r>
                                <m:r>
                                  <a:rPr lang="en-US" sz="1200" b="1" i="1" u="none" strike="noStrike" smtClean="0">
                                    <a:solidFill>
                                      <a:srgbClr val="000000"/>
                                    </a:solidFill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.</m:t>
                                </m:r>
                                <m:r>
                                  <a:rPr lang="en-US" sz="1200" b="1" i="1" u="none" strike="noStrike" smtClean="0">
                                    <a:solidFill>
                                      <a:srgbClr val="000000"/>
                                    </a:solidFill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𝟒𝟒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b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gt;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b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gt;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200" cap="none" spc="0" normalizeH="0" baseline="0" noProof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b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gt;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200" cap="none" spc="0" normalizeH="0" baseline="0" noProof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b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gt;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200" cap="none" spc="0" normalizeH="0" baseline="0" noProof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b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gt;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200" cap="none" spc="0" normalizeH="0" baseline="0" noProof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b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gt;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200" cap="none" spc="0" normalizeH="0" baseline="0" noProof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Arial" panose="020B0604020202020204" pitchFamily="34" charset="0"/>
                                  </a:rPr>
                                  <m:t>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Arial" panose="020B0604020202020204" pitchFamily="34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b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g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b"/>
                          <a:r>
                            <a:rPr lang="en-US" sz="1200" b="1" i="0" u="none" strike="noStrike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Cambria Math" panose="02040503050406030204" pitchFamily="18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3958423156"/>
                      </a:ext>
                    </a:extLst>
                  </a:tr>
                  <a:tr h="171095">
                    <a:tc gridSpan="11">
                      <a:txBody>
                        <a:bodyPr/>
                        <a:lstStyle/>
                        <a:p>
                          <a:pPr marL="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Surface DSC with 2-mm margins</a:t>
                          </a:r>
                        </a:p>
                      </a:txBody>
                      <a:tcPr marL="68580" marR="68580" marT="0" marB="0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1786108808"/>
                      </a:ext>
                    </a:extLst>
                  </a:tr>
                  <a:tr h="815633">
                    <a:tc>
                      <a:txBody>
                        <a:bodyPr/>
                        <a:lstStyle/>
                        <a:p>
                          <a:pPr marL="11430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Versus minimally curated 56-scan model</a:t>
                          </a: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ctr" rtl="0" fontAlgn="b"/>
                          <a:r>
                            <a:rPr lang="en-US" sz="1200" b="1" i="0" u="none" strike="noStrike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Cambria Math" panose="02040503050406030204" pitchFamily="18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b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gt;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200" cap="none" spc="0" normalizeH="0" baseline="0" noProof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𝟐𝟏𝟒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b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Arial" panose="020B0604020202020204" pitchFamily="34" charset="0"/>
                                  </a:rPr>
                                  <m:t>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Arial" panose="020B0604020202020204" pitchFamily="34" charset="0"/>
                                  </a:rPr>
                                  <m:t>𝟎𝟏𝟏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𝟏𝟑𝟔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b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Arial" panose="020B0604020202020204" pitchFamily="34" charset="0"/>
                                  </a:rPr>
                                  <m:t>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Arial" panose="020B0604020202020204" pitchFamily="34" charset="0"/>
                                  </a:rPr>
                                  <m:t>𝟎𝟎𝟗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𝟐𝟔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b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g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𝟓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2757718277"/>
                      </a:ext>
                    </a:extLst>
                  </a:tr>
                  <a:tr h="815633">
                    <a:tc>
                      <a:txBody>
                        <a:bodyPr/>
                        <a:lstStyle/>
                        <a:p>
                          <a:pPr marL="11430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Versus highly curated 244-scan model</a:t>
                          </a: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𝟎𝟎𝟏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b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𝟏𝟎𝟕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b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gt;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200" cap="none" spc="0" normalizeH="0" baseline="0" noProof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b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gt;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200" cap="none" spc="0" normalizeH="0" baseline="0" noProof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b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gt;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200" cap="none" spc="0" normalizeH="0" baseline="0" noProof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b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gt;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200" cap="none" spc="0" normalizeH="0" baseline="0" noProof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b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&gt; .</m:t>
                                </m:r>
                                <m:r>
                                  <a:rPr kumimoji="0" lang="en-US" sz="1200" b="1" i="1" u="none" strike="noStrike" kern="100" cap="none" spc="0" normalizeH="0" baseline="0" noProof="0" smtClean="0">
                                    <a:ln>
                                      <a:noFill/>
                                    </a:ln>
                                    <a:solidFill>
                                      <a:prstClr val="black"/>
                                    </a:solidFill>
                                    <a:effectLst/>
                                    <a:uLnTx/>
                                    <a:uFillTx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+mn-cs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kumimoji="0" lang="en-US" sz="1200" b="1" i="0" u="none" strike="noStrike" kern="1200" cap="none" spc="0" normalizeH="0" baseline="0" noProof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uLnTx/>
                            <a:uFillTx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b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Arial" panose="020B0604020202020204" pitchFamily="34" charset="0"/>
                                  </a:rPr>
                                  <m:t>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  <a:cs typeface="Arial" panose="020B0604020202020204" pitchFamily="34" charset="0"/>
                                  </a:rPr>
                                  <m:t>𝟎𝟎𝟑</m:t>
                                </m:r>
                              </m:oMath>
                            </m:oMathPara>
                          </a14:m>
                          <a:endParaRPr lang="en-US" sz="1200" b="1" kern="100"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b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Para xmlns:m="http://schemas.openxmlformats.org/officeDocument/2006/math">
                              <m:oMathParaPr>
                                <m:jc m:val="centerGroup"/>
                              </m:oMathParaPr>
                              <m:oMath xmlns:m="http://schemas.openxmlformats.org/officeDocument/2006/math"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&gt; .</m:t>
                                </m:r>
                                <m:r>
                                  <a:rPr lang="en-US" sz="1200" b="1" i="1" kern="100" smtClean="0">
                                    <a:effectLst/>
                                    <a:latin typeface="Cambria Math" panose="02040503050406030204" pitchFamily="18" charset="0"/>
                                    <a:ea typeface="Cambria Math" panose="02040503050406030204" pitchFamily="18" charset="0"/>
                                  </a:rPr>
                                  <m:t>𝟗𝟗𝟗</m:t>
                                </m:r>
                              </m:oMath>
                            </m:oMathPara>
                          </a14:m>
                          <a:endParaRPr lang="en-US" sz="1200" b="1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pPr algn="ctr" rtl="0" fontAlgn="b"/>
                          <a:r>
                            <a:rPr lang="en-US" sz="1200" b="1" i="0" u="none" strike="noStrike" dirty="0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Cambria Math" panose="02040503050406030204" pitchFamily="18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897063501"/>
                      </a:ext>
                    </a:extLst>
                  </a:tr>
                </a:tbl>
              </a:graphicData>
            </a:graphic>
          </p:graphicFrame>
        </mc:Choice>
        <mc:Fallback>
          <p:graphicFrame>
            <p:nvGraphicFramePr>
              <p:cNvPr id="2" name="Table 1">
                <a:extLst>
                  <a:ext uri="{FF2B5EF4-FFF2-40B4-BE49-F238E27FC236}">
                    <a16:creationId xmlns:a16="http://schemas.microsoft.com/office/drawing/2014/main" id="{65FCBC1F-E6E5-7676-227D-1D0B2602797C}"/>
                  </a:ext>
                </a:extLst>
              </p:cNvPr>
              <p:cNvGraphicFramePr>
                <a:graphicFrameLocks noGrp="1"/>
              </p:cNvGraphicFramePr>
              <p:nvPr/>
            </p:nvGraphicFramePr>
            <p:xfrm>
              <a:off x="662189" y="353711"/>
              <a:ext cx="10467358" cy="6146976"/>
            </p:xfrm>
            <a:graphic>
              <a:graphicData uri="http://schemas.openxmlformats.org/drawingml/2006/table">
                <a:tbl>
                  <a:tblPr firstRow="1" firstCol="1" bandRow="1">
                    <a:tableStyleId>{5940675A-B579-460E-94D1-54222C63F5DA}</a:tableStyleId>
                  </a:tblPr>
                  <a:tblGrid>
                    <a:gridCol w="1067041">
                      <a:extLst>
                        <a:ext uri="{9D8B030D-6E8A-4147-A177-3AD203B41FA5}">
                          <a16:colId xmlns:a16="http://schemas.microsoft.com/office/drawing/2014/main" val="1949119216"/>
                        </a:ext>
                      </a:extLst>
                    </a:gridCol>
                    <a:gridCol w="836115">
                      <a:extLst>
                        <a:ext uri="{9D8B030D-6E8A-4147-A177-3AD203B41FA5}">
                          <a16:colId xmlns:a16="http://schemas.microsoft.com/office/drawing/2014/main" val="834352100"/>
                        </a:ext>
                      </a:extLst>
                    </a:gridCol>
                    <a:gridCol w="951578">
                      <a:extLst>
                        <a:ext uri="{9D8B030D-6E8A-4147-A177-3AD203B41FA5}">
                          <a16:colId xmlns:a16="http://schemas.microsoft.com/office/drawing/2014/main" val="2740627536"/>
                        </a:ext>
                      </a:extLst>
                    </a:gridCol>
                    <a:gridCol w="951578">
                      <a:extLst>
                        <a:ext uri="{9D8B030D-6E8A-4147-A177-3AD203B41FA5}">
                          <a16:colId xmlns:a16="http://schemas.microsoft.com/office/drawing/2014/main" val="392156696"/>
                        </a:ext>
                      </a:extLst>
                    </a:gridCol>
                    <a:gridCol w="951578">
                      <a:extLst>
                        <a:ext uri="{9D8B030D-6E8A-4147-A177-3AD203B41FA5}">
                          <a16:colId xmlns:a16="http://schemas.microsoft.com/office/drawing/2014/main" val="1899616324"/>
                        </a:ext>
                      </a:extLst>
                    </a:gridCol>
                    <a:gridCol w="951578">
                      <a:extLst>
                        <a:ext uri="{9D8B030D-6E8A-4147-A177-3AD203B41FA5}">
                          <a16:colId xmlns:a16="http://schemas.microsoft.com/office/drawing/2014/main" val="4077769823"/>
                        </a:ext>
                      </a:extLst>
                    </a:gridCol>
                    <a:gridCol w="951578">
                      <a:extLst>
                        <a:ext uri="{9D8B030D-6E8A-4147-A177-3AD203B41FA5}">
                          <a16:colId xmlns:a16="http://schemas.microsoft.com/office/drawing/2014/main" val="3058248615"/>
                        </a:ext>
                      </a:extLst>
                    </a:gridCol>
                    <a:gridCol w="951578">
                      <a:extLst>
                        <a:ext uri="{9D8B030D-6E8A-4147-A177-3AD203B41FA5}">
                          <a16:colId xmlns:a16="http://schemas.microsoft.com/office/drawing/2014/main" val="771218125"/>
                        </a:ext>
                      </a:extLst>
                    </a:gridCol>
                    <a:gridCol w="951578">
                      <a:extLst>
                        <a:ext uri="{9D8B030D-6E8A-4147-A177-3AD203B41FA5}">
                          <a16:colId xmlns:a16="http://schemas.microsoft.com/office/drawing/2014/main" val="137810377"/>
                        </a:ext>
                      </a:extLst>
                    </a:gridCol>
                    <a:gridCol w="951578">
                      <a:extLst>
                        <a:ext uri="{9D8B030D-6E8A-4147-A177-3AD203B41FA5}">
                          <a16:colId xmlns:a16="http://schemas.microsoft.com/office/drawing/2014/main" val="274157669"/>
                        </a:ext>
                      </a:extLst>
                    </a:gridCol>
                    <a:gridCol w="951578">
                      <a:extLst>
                        <a:ext uri="{9D8B030D-6E8A-4147-A177-3AD203B41FA5}">
                          <a16:colId xmlns:a16="http://schemas.microsoft.com/office/drawing/2014/main" val="274360666"/>
                        </a:ext>
                      </a:extLst>
                    </a:gridCol>
                  </a:tblGrid>
                  <a:tr h="182880">
                    <a:tc rowSpan="2">
                      <a:txBody>
                        <a:bodyPr/>
                        <a:lstStyle/>
                        <a:p>
                          <a:pPr marL="0" marR="0" algn="l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 </a:t>
                          </a:r>
                        </a:p>
                        <a:p>
                          <a:pPr marL="0" marR="0" algn="l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 </a:t>
                          </a:r>
                        </a:p>
                      </a:txBody>
                      <a:tcPr marL="68580" marR="68580" marT="0" marB="0">
                        <a:solidFill>
                          <a:schemeClr val="bg2"/>
                        </a:solidFill>
                      </a:tcPr>
                    </a:tc>
                    <a:tc gridSpan="7">
                      <a:txBody>
                        <a:bodyPr/>
                        <a:lstStyle/>
                        <a:p>
                          <a:pPr algn="ctr"/>
                          <a:r>
                            <a:rPr lang="en-US" sz="1200" b="1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Mixed-Curation</a:t>
                          </a:r>
                          <a:r>
                            <a:rPr lang="en-US" sz="120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 </a:t>
                          </a: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models</a:t>
                          </a:r>
                          <a:endParaRPr lang="en-US" sz="120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gridSpan="3"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Highly curated models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tc hMerge="1"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/>
                    </a:tc>
                    <a:extLst>
                      <a:ext uri="{0D108BD9-81ED-4DB2-BD59-A6C34878D82A}">
                        <a16:rowId xmlns:a16="http://schemas.microsoft.com/office/drawing/2014/main" val="192860897"/>
                      </a:ext>
                    </a:extLst>
                  </a:tr>
                  <a:tr h="348050">
                    <a:tc vMerge="1">
                      <a:txBody>
                        <a:bodyPr/>
                        <a:lstStyle/>
                        <a:p>
                          <a:pPr marL="0" marR="0" algn="l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+mn-lt"/>
                              <a:ea typeface="+mn-ea"/>
                              <a:cs typeface="+mn-cs"/>
                            </a:rPr>
                            <a:t> </a:t>
                          </a: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56-scan 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142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284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710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1420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2130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2840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56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142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algn="ctr" defTabSz="914400" rtl="0" eaLnBrk="1" latinLnBrk="0" hangingPunct="1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200" b="1" kern="100">
                              <a:solidFill>
                                <a:schemeClr val="tx1"/>
                              </a:solidFill>
                              <a:effectLst/>
                              <a:latin typeface="Arial" panose="020B0604020202020204" pitchFamily="34" charset="0"/>
                              <a:ea typeface="+mn-ea"/>
                              <a:cs typeface="Arial" panose="020B0604020202020204" pitchFamily="34" charset="0"/>
                            </a:rPr>
                            <a:t>244-scan</a:t>
                          </a:r>
                        </a:p>
                      </a:txBody>
                      <a:tcPr marL="68580" marR="68580" marT="0" marB="0" anchor="ctr">
                        <a:solidFill>
                          <a:schemeClr val="bg2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3026451276"/>
                      </a:ext>
                    </a:extLst>
                  </a:tr>
                  <a:tr h="175197">
                    <a:tc gridSpan="11">
                      <a:txBody>
                        <a:bodyPr/>
                        <a:lstStyle/>
                        <a:p>
                          <a:pPr marL="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DSC</a:t>
                          </a:r>
                        </a:p>
                      </a:txBody>
                      <a:tcPr marL="68580" marR="68580" marT="0" marB="0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3137752485"/>
                      </a:ext>
                    </a:extLst>
                  </a:tr>
                  <a:tr h="815633">
                    <a:tc>
                      <a:txBody>
                        <a:bodyPr/>
                        <a:lstStyle/>
                        <a:p>
                          <a:pPr marL="11430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Versus minimally curated 56-scan model</a:t>
                          </a: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sz="1200" b="1" kern="100">
                              <a:effectLst/>
                              <a:latin typeface="Arial" panose="020B0604020202020204" pitchFamily="34" charset="0"/>
                              <a:ea typeface="Cambria Math" panose="02040503050406030204" pitchFamily="18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201333" t="-92188" r="-801333" b="-58125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301333" t="-92188" r="-701333" b="-58125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401333" t="-92188" r="-601333" b="-58125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501333" t="-92188" r="-501333" b="-58125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601333" t="-92188" r="-401333" b="-58125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701333" t="-92188" r="-301333" b="-58125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801333" t="-92188" r="-201333" b="-58125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901333" t="-92188" r="-101333" b="-58125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1001333" t="-92188" r="-1333" b="-581250"/>
                          </a:stretch>
                        </a:blipFill>
                      </a:tcPr>
                    </a:tc>
                    <a:extLst>
                      <a:ext uri="{0D108BD9-81ED-4DB2-BD59-A6C34878D82A}">
                        <a16:rowId xmlns:a16="http://schemas.microsoft.com/office/drawing/2014/main" val="4129130750"/>
                      </a:ext>
                    </a:extLst>
                  </a:tr>
                  <a:tr h="883920">
                    <a:tc>
                      <a:txBody>
                        <a:bodyPr/>
                        <a:lstStyle/>
                        <a:p>
                          <a:pPr marL="11430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Versus highly curated 244-scan model</a:t>
                          </a: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128788" t="-175714" r="-1024242" b="-431429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201333" t="-175714" r="-801333" b="-431429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301333" t="-175714" r="-701333" b="-431429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401333" t="-175714" r="-601333" b="-431429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501333" t="-175714" r="-501333" b="-431429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601333" t="-175714" r="-401333" b="-431429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701333" t="-175714" r="-301333" b="-431429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801333" t="-175714" r="-201333" b="-431429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901333" t="-175714" r="-101333" b="-431429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ctr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sz="1200" b="1" kern="100">
                              <a:effectLst/>
                              <a:latin typeface="Arial" panose="020B0604020202020204" pitchFamily="34" charset="0"/>
                              <a:ea typeface="Cambria Math" panose="02040503050406030204" pitchFamily="18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3615192787"/>
                      </a:ext>
                    </a:extLst>
                  </a:tr>
                  <a:tr h="171095">
                    <a:tc gridSpan="11">
                      <a:txBody>
                        <a:bodyPr/>
                        <a:lstStyle/>
                        <a:p>
                          <a:pPr marL="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Hausdorff distance, 95th percentile</a:t>
                          </a:r>
                        </a:p>
                      </a:txBody>
                      <a:tcPr marL="68580" marR="68580" marT="0" marB="0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1293607918"/>
                      </a:ext>
                    </a:extLst>
                  </a:tr>
                  <a:tr h="815633">
                    <a:tc>
                      <a:txBody>
                        <a:bodyPr/>
                        <a:lstStyle/>
                        <a:p>
                          <a:pPr marL="11430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Versus minimally curated 56-scan model</a:t>
                          </a: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ctr" rtl="0" fontAlgn="b"/>
                          <a:r>
                            <a:rPr lang="en-US" sz="1200" b="1" i="0" u="none" strike="noStrike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Cambria Math" panose="02040503050406030204" pitchFamily="18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201333" t="-316923" r="-801333" b="-344615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301333" t="-316923" r="-701333" b="-344615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401333" t="-316923" r="-601333" b="-344615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501333" t="-316923" r="-501333" b="-344615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601333" t="-316923" r="-401333" b="-344615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701333" t="-316923" r="-301333" b="-344615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801333" t="-316923" r="-201333" b="-344615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901333" t="-316923" r="-101333" b="-344615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1001333" t="-316923" r="-1333" b="-344615"/>
                          </a:stretch>
                        </a:blipFill>
                      </a:tcPr>
                    </a:tc>
                    <a:extLst>
                      <a:ext uri="{0D108BD9-81ED-4DB2-BD59-A6C34878D82A}">
                        <a16:rowId xmlns:a16="http://schemas.microsoft.com/office/drawing/2014/main" val="1678689836"/>
                      </a:ext>
                    </a:extLst>
                  </a:tr>
                  <a:tr h="883920">
                    <a:tc>
                      <a:txBody>
                        <a:bodyPr/>
                        <a:lstStyle/>
                        <a:p>
                          <a:pPr marL="11430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Versus highly curated 244-scan model</a:t>
                          </a: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128788" t="-392754" r="-1024242" b="-224638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201333" t="-392754" r="-801333" b="-224638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301333" t="-392754" r="-701333" b="-224638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401333" t="-392754" r="-601333" b="-224638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501333" t="-392754" r="-501333" b="-224638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601333" t="-392754" r="-401333" b="-224638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701333" t="-392754" r="-301333" b="-224638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801333" t="-392754" r="-201333" b="-224638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901333" t="-392754" r="-101333" b="-224638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pPr algn="ctr" rtl="0" fontAlgn="b"/>
                          <a:r>
                            <a:rPr lang="en-US" sz="1200" b="1" i="0" u="none" strike="noStrike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Cambria Math" panose="02040503050406030204" pitchFamily="18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3958423156"/>
                      </a:ext>
                    </a:extLst>
                  </a:tr>
                  <a:tr h="171095">
                    <a:tc gridSpan="11">
                      <a:txBody>
                        <a:bodyPr/>
                        <a:lstStyle/>
                        <a:p>
                          <a:pPr marL="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Surface DSC with 2-mm margins</a:t>
                          </a:r>
                        </a:p>
                      </a:txBody>
                      <a:tcPr marL="68580" marR="68580" marT="0" marB="0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tc hMerge="1">
                      <a:txBody>
                        <a:bodyPr/>
                        <a:lstStyle/>
                        <a:p>
                          <a:pPr algn="ctr" rtl="0" fontAlgn="ctr"/>
                          <a:endPara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ptos" panose="020B0004020202020204" pitchFamily="34" charset="0"/>
                          </a:endParaRP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1786108808"/>
                      </a:ext>
                    </a:extLst>
                  </a:tr>
                  <a:tr h="815633">
                    <a:tc>
                      <a:txBody>
                        <a:bodyPr/>
                        <a:lstStyle/>
                        <a:p>
                          <a:pPr marL="11430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Versus minimally curated 56-scan model</a:t>
                          </a: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pPr algn="ctr" rtl="0" fontAlgn="b"/>
                          <a:r>
                            <a:rPr lang="en-US" sz="1200" b="1" i="0" u="none" strike="noStrike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Cambria Math" panose="02040503050406030204" pitchFamily="18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</a:txBody>
                      <a:tcPr marL="9525" marR="9525" marT="9525" marB="0" anchor="ctr"/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201333" t="-553125" r="-801333" b="-120313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301333" t="-553125" r="-701333" b="-120313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401333" t="-553125" r="-601333" b="-120313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501333" t="-553125" r="-501333" b="-120313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601333" t="-553125" r="-401333" b="-120313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701333" t="-553125" r="-301333" b="-120313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801333" t="-553125" r="-201333" b="-120313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901333" t="-553125" r="-101333" b="-120313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1001333" t="-553125" r="-1333" b="-120313"/>
                          </a:stretch>
                        </a:blipFill>
                      </a:tcPr>
                    </a:tc>
                    <a:extLst>
                      <a:ext uri="{0D108BD9-81ED-4DB2-BD59-A6C34878D82A}">
                        <a16:rowId xmlns:a16="http://schemas.microsoft.com/office/drawing/2014/main" val="2757718277"/>
                      </a:ext>
                    </a:extLst>
                  </a:tr>
                  <a:tr h="883920">
                    <a:tc>
                      <a:txBody>
                        <a:bodyPr/>
                        <a:lstStyle/>
                        <a:p>
                          <a:pPr marL="114300" marR="0">
                            <a:lnSpc>
                              <a:spcPct val="107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</a:pPr>
                          <a:r>
                            <a:rPr lang="en-US" sz="1100" b="1" kern="100">
                              <a:effectLst/>
                              <a:latin typeface="Arial" panose="020B0604020202020204" pitchFamily="34" charset="0"/>
                              <a:ea typeface="Calibri" panose="020F0502020204030204" pitchFamily="34" charset="0"/>
                              <a:cs typeface="Arial" panose="020B0604020202020204" pitchFamily="34" charset="0"/>
                            </a:rPr>
                            <a:t>Versus highly curated 244-scan model</a:t>
                          </a:r>
                        </a:p>
                      </a:txBody>
                      <a:tcPr marL="68580" marR="68580" marT="0" marB="0"/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128788" t="-597143" r="-1024242" b="-1000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201333" t="-597143" r="-801333" b="-1000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301333" t="-597143" r="-701333" b="-1000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401333" t="-597143" r="-601333" b="-1000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501333" t="-597143" r="-501333" b="-1000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601333" t="-597143" r="-401333" b="-1000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701333" t="-597143" r="-301333" b="-1000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801333" t="-597143" r="-201333" b="-1000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 marL="9525" marR="9525" marT="9525" marB="0" anchor="ctr">
                        <a:blipFill>
                          <a:blip r:embed="rId2"/>
                          <a:stretch>
                            <a:fillRect l="-901333" t="-597143" r="-101333" b="-1000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pPr algn="ctr" rtl="0" fontAlgn="b"/>
                          <a:r>
                            <a:rPr lang="en-US" sz="1200" b="1" i="0" u="none" strike="noStrike" dirty="0">
                              <a:solidFill>
                                <a:srgbClr val="000000"/>
                              </a:solidFill>
                              <a:effectLst/>
                              <a:latin typeface="Arial" panose="020B0604020202020204" pitchFamily="34" charset="0"/>
                              <a:ea typeface="Cambria Math" panose="02040503050406030204" pitchFamily="18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</a:txBody>
                      <a:tcPr marL="9525" marR="9525" marT="9525" marB="0" anchor="ctr"/>
                    </a:tc>
                    <a:extLst>
                      <a:ext uri="{0D108BD9-81ED-4DB2-BD59-A6C34878D82A}">
                        <a16:rowId xmlns:a16="http://schemas.microsoft.com/office/drawing/2014/main" val="897063501"/>
                      </a:ext>
                    </a:extLst>
                  </a:tr>
                </a:tbl>
              </a:graphicData>
            </a:graphic>
          </p:graphicFrame>
        </mc:Fallback>
      </mc:AlternateContent>
      <p:sp>
        <p:nvSpPr>
          <p:cNvPr id="3" name="TextBox 2">
            <a:extLst>
              <a:ext uri="{FF2B5EF4-FFF2-40B4-BE49-F238E27FC236}">
                <a16:creationId xmlns:a16="http://schemas.microsoft.com/office/drawing/2014/main" id="{849C3130-700C-4272-0850-0B85317611CB}"/>
              </a:ext>
            </a:extLst>
          </p:cNvPr>
          <p:cNvSpPr txBox="1"/>
          <p:nvPr/>
        </p:nvSpPr>
        <p:spPr>
          <a:xfrm>
            <a:off x="2297989" y="6463205"/>
            <a:ext cx="719575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 Table 3.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-value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f Dunn’s multiple comparisons test. Model performance on BTCV Test Set.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Hausdorff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distance (HD), Surface Dice similarity coefficient with 2mm margin  (SD 2mm) </a:t>
            </a:r>
          </a:p>
        </p:txBody>
      </p:sp>
    </p:spTree>
    <p:extLst>
      <p:ext uri="{BB962C8B-B14F-4D97-AF65-F5344CB8AC3E}">
        <p14:creationId xmlns:p14="http://schemas.microsoft.com/office/powerpoint/2010/main" val="38767454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96</Words>
  <Application>Microsoft Macintosh PowerPoint</Application>
  <PresentationFormat>Widescreen</PresentationFormat>
  <Paragraphs>22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ptos</vt:lpstr>
      <vt:lpstr>Aptos Display</vt:lpstr>
      <vt:lpstr>Arial</vt:lpstr>
      <vt:lpstr>Cambria Math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astelo,Austin H</dc:creator>
  <cp:lastModifiedBy>Castelo,Austin H</cp:lastModifiedBy>
  <cp:revision>1</cp:revision>
  <dcterms:created xsi:type="dcterms:W3CDTF">2026-02-03T15:10:01Z</dcterms:created>
  <dcterms:modified xsi:type="dcterms:W3CDTF">2026-02-03T15:10:23Z</dcterms:modified>
</cp:coreProperties>
</file>